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73" d="100"/>
          <a:sy n="73" d="100"/>
        </p:scale>
        <p:origin x="3222" y="2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Avandenbiggelaar\Desktop\PNG%20OCT%202019\Sarah%20Javati%20PCV13%20WOCBA\ELISA%20results%20non-pregnant%20PCV13.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1</a:t>
            </a:r>
          </a:p>
        </c:rich>
      </c:tx>
      <c:overlay val="0"/>
    </c:title>
    <c:autoTitleDeleted val="0"/>
    <c:plotArea>
      <c:layout/>
      <c:scatterChart>
        <c:scatterStyle val="lineMarker"/>
        <c:varyColors val="0"/>
        <c:ser>
          <c:idx val="0"/>
          <c:order val="0"/>
          <c:tx>
            <c:strRef>
              <c:f>'Fold change'!$E$1</c:f>
              <c:strCache>
                <c:ptCount val="1"/>
                <c:pt idx="0">
                  <c:v>S1_2</c:v>
                </c:pt>
              </c:strCache>
            </c:strRef>
          </c:tx>
          <c:spPr>
            <a:ln w="28575">
              <a:noFill/>
            </a:ln>
          </c:spPr>
          <c:xVal>
            <c:numRef>
              <c:f>'Fold change'!$D$2:$D$49</c:f>
              <c:numCache>
                <c:formatCode>General</c:formatCode>
                <c:ptCount val="48"/>
                <c:pt idx="0">
                  <c:v>2.4870000000000001</c:v>
                </c:pt>
                <c:pt idx="1">
                  <c:v>3.8759999999999999</c:v>
                </c:pt>
                <c:pt idx="2">
                  <c:v>4.8220000000000001</c:v>
                </c:pt>
                <c:pt idx="3">
                  <c:v>2.415</c:v>
                </c:pt>
                <c:pt idx="4">
                  <c:v>3.3420000000000001</c:v>
                </c:pt>
                <c:pt idx="5">
                  <c:v>2.3210000000000002</c:v>
                </c:pt>
                <c:pt idx="6">
                  <c:v>2.3119999999999998</c:v>
                </c:pt>
                <c:pt idx="7">
                  <c:v>5.65</c:v>
                </c:pt>
                <c:pt idx="8">
                  <c:v>4.0229999999999997</c:v>
                </c:pt>
                <c:pt idx="9">
                  <c:v>4.4080000000000004</c:v>
                </c:pt>
                <c:pt idx="10">
                  <c:v>11.791</c:v>
                </c:pt>
                <c:pt idx="11">
                  <c:v>2.2599999999999998</c:v>
                </c:pt>
                <c:pt idx="12">
                  <c:v>4.1360000000000001</c:v>
                </c:pt>
                <c:pt idx="13">
                  <c:v>2.206</c:v>
                </c:pt>
                <c:pt idx="14">
                  <c:v>6.0259999999999998</c:v>
                </c:pt>
                <c:pt idx="15">
                  <c:v>5.9089999999999998</c:v>
                </c:pt>
                <c:pt idx="16">
                  <c:v>8.0670000000000002</c:v>
                </c:pt>
                <c:pt idx="17">
                  <c:v>2.6</c:v>
                </c:pt>
                <c:pt idx="18">
                  <c:v>3.0289999999999999</c:v>
                </c:pt>
                <c:pt idx="19">
                  <c:v>1.6259999999999999</c:v>
                </c:pt>
                <c:pt idx="20">
                  <c:v>2.8130000000000002</c:v>
                </c:pt>
                <c:pt idx="21">
                  <c:v>4.5270000000000001</c:v>
                </c:pt>
                <c:pt idx="22">
                  <c:v>0.72099999999999997</c:v>
                </c:pt>
                <c:pt idx="23">
                  <c:v>3.3730000000000002</c:v>
                </c:pt>
                <c:pt idx="24">
                  <c:v>5.7839999999999998</c:v>
                </c:pt>
                <c:pt idx="25">
                  <c:v>3.97</c:v>
                </c:pt>
                <c:pt idx="26">
                  <c:v>12.327999999999999</c:v>
                </c:pt>
                <c:pt idx="27">
                  <c:v>7.5789999999999997</c:v>
                </c:pt>
                <c:pt idx="28">
                  <c:v>6.8819999999999997</c:v>
                </c:pt>
                <c:pt idx="29">
                  <c:v>9.3960000000000008</c:v>
                </c:pt>
                <c:pt idx="30">
                  <c:v>4.7960000000000003</c:v>
                </c:pt>
                <c:pt idx="31">
                  <c:v>1.296</c:v>
                </c:pt>
                <c:pt idx="32">
                  <c:v>7.3079999999999998</c:v>
                </c:pt>
                <c:pt idx="33">
                  <c:v>7.1769999999999996</c:v>
                </c:pt>
                <c:pt idx="34">
                  <c:v>6.3040000000000003</c:v>
                </c:pt>
                <c:pt idx="35">
                  <c:v>6.7119999999999997</c:v>
                </c:pt>
                <c:pt idx="36">
                  <c:v>25.169</c:v>
                </c:pt>
                <c:pt idx="37">
                  <c:v>13.26</c:v>
                </c:pt>
                <c:pt idx="38">
                  <c:v>7.1159999999999997</c:v>
                </c:pt>
                <c:pt idx="39">
                  <c:v>4.1420000000000003</c:v>
                </c:pt>
                <c:pt idx="40">
                  <c:v>0.35499999999999998</c:v>
                </c:pt>
                <c:pt idx="41">
                  <c:v>4.5090000000000003</c:v>
                </c:pt>
                <c:pt idx="42">
                  <c:v>8.8680000000000003</c:v>
                </c:pt>
                <c:pt idx="43">
                  <c:v>11.743</c:v>
                </c:pt>
                <c:pt idx="44">
                  <c:v>3.3889999999999998</c:v>
                </c:pt>
                <c:pt idx="45">
                  <c:v>8.4030000000000005</c:v>
                </c:pt>
                <c:pt idx="46">
                  <c:v>2.1560000000000001</c:v>
                </c:pt>
                <c:pt idx="47">
                  <c:v>10.839</c:v>
                </c:pt>
              </c:numCache>
            </c:numRef>
          </c:xVal>
          <c:yVal>
            <c:numRef>
              <c:f>'Fold change'!$E$2:$E$49</c:f>
              <c:numCache>
                <c:formatCode>General</c:formatCode>
                <c:ptCount val="48"/>
                <c:pt idx="0">
                  <c:v>8.5549999999999997</c:v>
                </c:pt>
                <c:pt idx="1">
                  <c:v>10.574999999999999</c:v>
                </c:pt>
                <c:pt idx="2">
                  <c:v>18.869</c:v>
                </c:pt>
                <c:pt idx="3">
                  <c:v>5.9820000000000002</c:v>
                </c:pt>
                <c:pt idx="4">
                  <c:v>14.081</c:v>
                </c:pt>
                <c:pt idx="5">
                  <c:v>4.1870000000000003</c:v>
                </c:pt>
                <c:pt idx="6">
                  <c:v>5.0469999999999997</c:v>
                </c:pt>
                <c:pt idx="7">
                  <c:v>5.9349999999999996</c:v>
                </c:pt>
                <c:pt idx="8">
                  <c:v>10.75</c:v>
                </c:pt>
                <c:pt idx="9">
                  <c:v>4.8049999999999997</c:v>
                </c:pt>
                <c:pt idx="10">
                  <c:v>13.855</c:v>
                </c:pt>
                <c:pt idx="11">
                  <c:v>2.6280000000000001</c:v>
                </c:pt>
                <c:pt idx="12">
                  <c:v>5.17</c:v>
                </c:pt>
                <c:pt idx="13">
                  <c:v>2.8519999999999999</c:v>
                </c:pt>
                <c:pt idx="14">
                  <c:v>5.5439999999999996</c:v>
                </c:pt>
                <c:pt idx="15">
                  <c:v>7.1639999999999997</c:v>
                </c:pt>
                <c:pt idx="16">
                  <c:v>3.9239999999999999</c:v>
                </c:pt>
                <c:pt idx="17">
                  <c:v>17.05</c:v>
                </c:pt>
                <c:pt idx="18">
                  <c:v>5.3570000000000002</c:v>
                </c:pt>
                <c:pt idx="19">
                  <c:v>2.6680000000000001</c:v>
                </c:pt>
                <c:pt idx="20">
                  <c:v>2.89</c:v>
                </c:pt>
                <c:pt idx="21">
                  <c:v>4.3529999999999998</c:v>
                </c:pt>
                <c:pt idx="22">
                  <c:v>3.7389999999999999</c:v>
                </c:pt>
                <c:pt idx="23">
                  <c:v>3.3959999999999999</c:v>
                </c:pt>
                <c:pt idx="24">
                  <c:v>13.074999999999999</c:v>
                </c:pt>
                <c:pt idx="25">
                  <c:v>21.257000000000001</c:v>
                </c:pt>
                <c:pt idx="26">
                  <c:v>14.526</c:v>
                </c:pt>
                <c:pt idx="27">
                  <c:v>11.416</c:v>
                </c:pt>
                <c:pt idx="28">
                  <c:v>17.585000000000001</c:v>
                </c:pt>
                <c:pt idx="29">
                  <c:v>9.7759999999999998</c:v>
                </c:pt>
                <c:pt idx="30">
                  <c:v>16.132999999999999</c:v>
                </c:pt>
                <c:pt idx="31">
                  <c:v>6.4320000000000004</c:v>
                </c:pt>
                <c:pt idx="32">
                  <c:v>12.565</c:v>
                </c:pt>
                <c:pt idx="33">
                  <c:v>13.492000000000001</c:v>
                </c:pt>
                <c:pt idx="34">
                  <c:v>8.5579999999999998</c:v>
                </c:pt>
                <c:pt idx="35">
                  <c:v>9.3460000000000001</c:v>
                </c:pt>
                <c:pt idx="36">
                  <c:v>44.947000000000003</c:v>
                </c:pt>
                <c:pt idx="37">
                  <c:v>19.126999999999999</c:v>
                </c:pt>
                <c:pt idx="38">
                  <c:v>9.1359999999999992</c:v>
                </c:pt>
                <c:pt idx="39">
                  <c:v>9.8670000000000009</c:v>
                </c:pt>
                <c:pt idx="40">
                  <c:v>3.597</c:v>
                </c:pt>
                <c:pt idx="41">
                  <c:v>6.5720000000000001</c:v>
                </c:pt>
                <c:pt idx="42">
                  <c:v>23.393999999999998</c:v>
                </c:pt>
                <c:pt idx="43">
                  <c:v>41.921999999999997</c:v>
                </c:pt>
                <c:pt idx="44">
                  <c:v>6.9089999999999998</c:v>
                </c:pt>
                <c:pt idx="45">
                  <c:v>33.729999999999997</c:v>
                </c:pt>
                <c:pt idx="46">
                  <c:v>6.117</c:v>
                </c:pt>
                <c:pt idx="47">
                  <c:v>14.058</c:v>
                </c:pt>
              </c:numCache>
            </c:numRef>
          </c:yVal>
          <c:smooth val="0"/>
          <c:extLst>
            <c:ext xmlns:c16="http://schemas.microsoft.com/office/drawing/2014/chart" uri="{C3380CC4-5D6E-409C-BE32-E72D297353CC}">
              <c16:uniqueId val="{00000000-5103-4358-AE99-477D4241A5F9}"/>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5103-4358-AE99-477D4241A5F9}"/>
            </c:ext>
          </c:extLst>
        </c:ser>
        <c:dLbls>
          <c:showLegendKey val="0"/>
          <c:showVal val="0"/>
          <c:showCatName val="0"/>
          <c:showSerName val="0"/>
          <c:showPercent val="0"/>
          <c:showBubbleSize val="0"/>
        </c:dLbls>
        <c:axId val="156920448"/>
        <c:axId val="168964864"/>
      </c:scatterChart>
      <c:valAx>
        <c:axId val="156920448"/>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dirty="0">
                    <a:latin typeface="Times New Roman" panose="02020603050405020304" pitchFamily="18" charset="0"/>
                    <a:cs typeface="Times New Roman" panose="02020603050405020304" pitchFamily="18" charset="0"/>
                  </a:rPr>
                  <a:t>µg</a:t>
                </a:r>
                <a:r>
                  <a:rPr lang="en-US" dirty="0"/>
                  <a:t>/mL)</a:t>
                </a:r>
              </a:p>
            </c:rich>
          </c:tx>
          <c:overlay val="0"/>
        </c:title>
        <c:numFmt formatCode="General" sourceLinked="1"/>
        <c:majorTickMark val="out"/>
        <c:minorTickMark val="out"/>
        <c:tickLblPos val="nextTo"/>
        <c:crossAx val="168964864"/>
        <c:crossesAt val="0.1"/>
        <c:crossBetween val="midCat"/>
      </c:valAx>
      <c:valAx>
        <c:axId val="168964864"/>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AU" sz="1100" baseline="0" dirty="0">
                    <a:latin typeface="Times New Roman" panose="02020603050405020304" pitchFamily="18" charset="0"/>
                    <a:cs typeface="Times New Roman" panose="02020603050405020304" pitchFamily="18" charset="0"/>
                  </a:rPr>
                  <a:t>µg</a:t>
                </a:r>
                <a:r>
                  <a:rPr lang="en-AU" sz="1100" baseline="0" dirty="0"/>
                  <a:t>/mL)</a:t>
                </a:r>
                <a:endParaRPr lang="en-AU" sz="1100" dirty="0"/>
              </a:p>
            </c:rich>
          </c:tx>
          <c:overlay val="0"/>
        </c:title>
        <c:numFmt formatCode="General" sourceLinked="1"/>
        <c:majorTickMark val="out"/>
        <c:minorTickMark val="out"/>
        <c:tickLblPos val="nextTo"/>
        <c:crossAx val="156920448"/>
        <c:crossesAt val="0.1"/>
        <c:crossBetween val="midCat"/>
      </c:valAx>
    </c:plotArea>
    <c:plotVisOnly val="1"/>
    <c:dispBlanksAs val="gap"/>
    <c:showDLblsOverMax val="0"/>
  </c:chart>
  <c:spPr>
    <a:ln>
      <a:noFill/>
    </a:ln>
  </c:sp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18C</a:t>
            </a:r>
          </a:p>
        </c:rich>
      </c:tx>
      <c:overlay val="0"/>
    </c:title>
    <c:autoTitleDeleted val="0"/>
    <c:plotArea>
      <c:layout/>
      <c:scatterChart>
        <c:scatterStyle val="lineMarker"/>
        <c:varyColors val="0"/>
        <c:ser>
          <c:idx val="0"/>
          <c:order val="0"/>
          <c:tx>
            <c:strRef>
              <c:f>'Fold change'!$AR$1</c:f>
              <c:strCache>
                <c:ptCount val="1"/>
                <c:pt idx="0">
                  <c:v>S18C_1</c:v>
                </c:pt>
              </c:strCache>
            </c:strRef>
          </c:tx>
          <c:spPr>
            <a:ln w="28575">
              <a:noFill/>
            </a:ln>
          </c:spPr>
          <c:xVal>
            <c:numRef>
              <c:f>'Fold change'!$AR$2:$AR$49</c:f>
              <c:numCache>
                <c:formatCode>General</c:formatCode>
                <c:ptCount val="48"/>
                <c:pt idx="0">
                  <c:v>2.6840000000000002</c:v>
                </c:pt>
                <c:pt idx="1">
                  <c:v>7.0490000000000004</c:v>
                </c:pt>
                <c:pt idx="2">
                  <c:v>1.7529999999999999</c:v>
                </c:pt>
                <c:pt idx="3">
                  <c:v>2.1339999999999999</c:v>
                </c:pt>
                <c:pt idx="4">
                  <c:v>2.7810000000000001</c:v>
                </c:pt>
                <c:pt idx="5">
                  <c:v>3.423</c:v>
                </c:pt>
                <c:pt idx="6">
                  <c:v>2.7839999999999998</c:v>
                </c:pt>
                <c:pt idx="7">
                  <c:v>4.4189999999999996</c:v>
                </c:pt>
                <c:pt idx="8">
                  <c:v>1.5089999999999999</c:v>
                </c:pt>
                <c:pt idx="9">
                  <c:v>2.4209999999999998</c:v>
                </c:pt>
                <c:pt idx="10">
                  <c:v>4.5990000000000002</c:v>
                </c:pt>
                <c:pt idx="11">
                  <c:v>0.64</c:v>
                </c:pt>
                <c:pt idx="12">
                  <c:v>4.173</c:v>
                </c:pt>
                <c:pt idx="13">
                  <c:v>2.4460000000000002</c:v>
                </c:pt>
                <c:pt idx="14">
                  <c:v>3.2109999999999999</c:v>
                </c:pt>
                <c:pt idx="15">
                  <c:v>5.4690000000000003</c:v>
                </c:pt>
                <c:pt idx="16">
                  <c:v>2.5939999999999999</c:v>
                </c:pt>
                <c:pt idx="17">
                  <c:v>1.167</c:v>
                </c:pt>
                <c:pt idx="18">
                  <c:v>0.46300000000000002</c:v>
                </c:pt>
                <c:pt idx="19">
                  <c:v>0.504</c:v>
                </c:pt>
                <c:pt idx="20">
                  <c:v>2.5129999999999999</c:v>
                </c:pt>
                <c:pt idx="21">
                  <c:v>3.36</c:v>
                </c:pt>
                <c:pt idx="22">
                  <c:v>1.3260000000000001</c:v>
                </c:pt>
                <c:pt idx="23">
                  <c:v>3.0390000000000001</c:v>
                </c:pt>
                <c:pt idx="24">
                  <c:v>3.762</c:v>
                </c:pt>
                <c:pt idx="25">
                  <c:v>4.2750000000000004</c:v>
                </c:pt>
                <c:pt idx="26">
                  <c:v>5.9429999999999996</c:v>
                </c:pt>
                <c:pt idx="27">
                  <c:v>4.9219999999999997</c:v>
                </c:pt>
                <c:pt idx="28">
                  <c:v>7.2069999999999999</c:v>
                </c:pt>
                <c:pt idx="29">
                  <c:v>5.8940000000000001</c:v>
                </c:pt>
                <c:pt idx="30">
                  <c:v>11.472</c:v>
                </c:pt>
                <c:pt idx="31">
                  <c:v>0.95399999999999996</c:v>
                </c:pt>
                <c:pt idx="32">
                  <c:v>5.7169999999999996</c:v>
                </c:pt>
                <c:pt idx="33">
                  <c:v>6.9429999999999996</c:v>
                </c:pt>
                <c:pt idx="34">
                  <c:v>5.2789999999999999</c:v>
                </c:pt>
                <c:pt idx="35">
                  <c:v>6.9649999999999999</c:v>
                </c:pt>
                <c:pt idx="36">
                  <c:v>12.99</c:v>
                </c:pt>
                <c:pt idx="37">
                  <c:v>12.115</c:v>
                </c:pt>
                <c:pt idx="38">
                  <c:v>7.8979999999999997</c:v>
                </c:pt>
                <c:pt idx="39">
                  <c:v>3.2269999999999999</c:v>
                </c:pt>
                <c:pt idx="40">
                  <c:v>0.66800000000000004</c:v>
                </c:pt>
                <c:pt idx="41">
                  <c:v>2.6429999999999998</c:v>
                </c:pt>
                <c:pt idx="42">
                  <c:v>10.186999999999999</c:v>
                </c:pt>
                <c:pt idx="43">
                  <c:v>5.25</c:v>
                </c:pt>
                <c:pt idx="44">
                  <c:v>4.55</c:v>
                </c:pt>
                <c:pt idx="45">
                  <c:v>2.835</c:v>
                </c:pt>
                <c:pt idx="46">
                  <c:v>1.8029999999999999</c:v>
                </c:pt>
                <c:pt idx="47">
                  <c:v>7.5170000000000003</c:v>
                </c:pt>
              </c:numCache>
            </c:numRef>
          </c:xVal>
          <c:yVal>
            <c:numRef>
              <c:f>'Fold change'!$AS$2:$AS$49</c:f>
              <c:numCache>
                <c:formatCode>General</c:formatCode>
                <c:ptCount val="48"/>
                <c:pt idx="0">
                  <c:v>3.4390000000000001</c:v>
                </c:pt>
                <c:pt idx="1">
                  <c:v>23.03</c:v>
                </c:pt>
                <c:pt idx="2">
                  <c:v>3.036</c:v>
                </c:pt>
                <c:pt idx="3">
                  <c:v>2.7370000000000001</c:v>
                </c:pt>
                <c:pt idx="4">
                  <c:v>7.9790000000000001</c:v>
                </c:pt>
                <c:pt idx="5">
                  <c:v>39.165999999999997</c:v>
                </c:pt>
                <c:pt idx="6">
                  <c:v>9.8569999999999993</c:v>
                </c:pt>
                <c:pt idx="7">
                  <c:v>10.676</c:v>
                </c:pt>
                <c:pt idx="8">
                  <c:v>17.268999999999998</c:v>
                </c:pt>
                <c:pt idx="9">
                  <c:v>8.4659999999999993</c:v>
                </c:pt>
                <c:pt idx="10">
                  <c:v>6.5030000000000001</c:v>
                </c:pt>
                <c:pt idx="11">
                  <c:v>6.0519999999999996</c:v>
                </c:pt>
                <c:pt idx="12">
                  <c:v>4.9539999999999997</c:v>
                </c:pt>
                <c:pt idx="13">
                  <c:v>10.047000000000001</c:v>
                </c:pt>
                <c:pt idx="14">
                  <c:v>7.7489999999999997</c:v>
                </c:pt>
                <c:pt idx="15">
                  <c:v>7.968</c:v>
                </c:pt>
                <c:pt idx="16">
                  <c:v>12.385999999999999</c:v>
                </c:pt>
                <c:pt idx="17">
                  <c:v>3.1040000000000001</c:v>
                </c:pt>
                <c:pt idx="18">
                  <c:v>3.96</c:v>
                </c:pt>
                <c:pt idx="19">
                  <c:v>2.3820000000000001</c:v>
                </c:pt>
                <c:pt idx="20">
                  <c:v>4.0010000000000003</c:v>
                </c:pt>
                <c:pt idx="21">
                  <c:v>19.792000000000002</c:v>
                </c:pt>
                <c:pt idx="22">
                  <c:v>1.722</c:v>
                </c:pt>
                <c:pt idx="23">
                  <c:v>12.28</c:v>
                </c:pt>
                <c:pt idx="24">
                  <c:v>15.997</c:v>
                </c:pt>
                <c:pt idx="25">
                  <c:v>7.0090000000000003</c:v>
                </c:pt>
                <c:pt idx="26">
                  <c:v>10.449</c:v>
                </c:pt>
                <c:pt idx="27">
                  <c:v>12.206</c:v>
                </c:pt>
                <c:pt idx="28">
                  <c:v>24.038</c:v>
                </c:pt>
                <c:pt idx="29">
                  <c:v>11.137</c:v>
                </c:pt>
                <c:pt idx="30">
                  <c:v>37.243000000000002</c:v>
                </c:pt>
                <c:pt idx="31">
                  <c:v>5.5910000000000002</c:v>
                </c:pt>
                <c:pt idx="32">
                  <c:v>7.3129999999999997</c:v>
                </c:pt>
                <c:pt idx="33">
                  <c:v>7.2320000000000002</c:v>
                </c:pt>
                <c:pt idx="34">
                  <c:v>13.359</c:v>
                </c:pt>
                <c:pt idx="35">
                  <c:v>11.407</c:v>
                </c:pt>
                <c:pt idx="36">
                  <c:v>24.202000000000002</c:v>
                </c:pt>
                <c:pt idx="37">
                  <c:v>26.338000000000001</c:v>
                </c:pt>
                <c:pt idx="38">
                  <c:v>7.915</c:v>
                </c:pt>
                <c:pt idx="39">
                  <c:v>10.223000000000001</c:v>
                </c:pt>
                <c:pt idx="40">
                  <c:v>6.6689999999999996</c:v>
                </c:pt>
                <c:pt idx="41">
                  <c:v>3.34</c:v>
                </c:pt>
                <c:pt idx="42">
                  <c:v>7.5750000000000002</c:v>
                </c:pt>
                <c:pt idx="43">
                  <c:v>14.462</c:v>
                </c:pt>
                <c:pt idx="44">
                  <c:v>14.614000000000001</c:v>
                </c:pt>
                <c:pt idx="45">
                  <c:v>32.323999999999998</c:v>
                </c:pt>
                <c:pt idx="46">
                  <c:v>27.449000000000002</c:v>
                </c:pt>
                <c:pt idx="47">
                  <c:v>23.1</c:v>
                </c:pt>
              </c:numCache>
            </c:numRef>
          </c:yVal>
          <c:smooth val="0"/>
          <c:extLst>
            <c:ext xmlns:c16="http://schemas.microsoft.com/office/drawing/2014/chart" uri="{C3380CC4-5D6E-409C-BE32-E72D297353CC}">
              <c16:uniqueId val="{00000000-717B-4EDE-9E47-375355998F8B}"/>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717B-4EDE-9E47-375355998F8B}"/>
            </c:ext>
          </c:extLst>
        </c:ser>
        <c:dLbls>
          <c:showLegendKey val="0"/>
          <c:showVal val="0"/>
          <c:showCatName val="0"/>
          <c:showSerName val="0"/>
          <c:showPercent val="0"/>
          <c:showBubbleSize val="0"/>
        </c:dLbls>
        <c:axId val="134419584"/>
        <c:axId val="134421504"/>
      </c:scatterChart>
      <c:valAx>
        <c:axId val="134419584"/>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4421504"/>
        <c:crossesAt val="0.1"/>
        <c:crossBetween val="midCat"/>
      </c:valAx>
      <c:valAx>
        <c:axId val="134421504"/>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4419584"/>
        <c:crossesAt val="0.1"/>
        <c:crossBetween val="midCat"/>
      </c:valAx>
    </c:plotArea>
    <c:plotVisOnly val="1"/>
    <c:dispBlanksAs val="gap"/>
    <c:showDLblsOverMax val="0"/>
  </c:chart>
  <c:spPr>
    <a:ln>
      <a:noFill/>
    </a:ln>
  </c:sp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19A</a:t>
            </a:r>
          </a:p>
        </c:rich>
      </c:tx>
      <c:overlay val="0"/>
    </c:title>
    <c:autoTitleDeleted val="0"/>
    <c:plotArea>
      <c:layout>
        <c:manualLayout>
          <c:layoutTarget val="inner"/>
          <c:xMode val="edge"/>
          <c:yMode val="edge"/>
          <c:x val="0.25138726023258323"/>
          <c:y val="0.15912542122458911"/>
          <c:w val="0.66350104685072964"/>
          <c:h val="0.61164338785495365"/>
        </c:manualLayout>
      </c:layout>
      <c:scatterChart>
        <c:scatterStyle val="lineMarker"/>
        <c:varyColors val="0"/>
        <c:ser>
          <c:idx val="0"/>
          <c:order val="0"/>
          <c:tx>
            <c:strRef>
              <c:f>'Fold change'!$AV$1</c:f>
              <c:strCache>
                <c:ptCount val="1"/>
                <c:pt idx="0">
                  <c:v>S19A_1</c:v>
                </c:pt>
              </c:strCache>
            </c:strRef>
          </c:tx>
          <c:spPr>
            <a:ln w="28575">
              <a:noFill/>
            </a:ln>
          </c:spPr>
          <c:xVal>
            <c:numRef>
              <c:f>'Fold change'!$AV$2:$AV$49</c:f>
              <c:numCache>
                <c:formatCode>General</c:formatCode>
                <c:ptCount val="48"/>
                <c:pt idx="0">
                  <c:v>8.7829999999999995</c:v>
                </c:pt>
                <c:pt idx="1">
                  <c:v>10.286</c:v>
                </c:pt>
                <c:pt idx="2">
                  <c:v>7.0739999999999998</c:v>
                </c:pt>
                <c:pt idx="3">
                  <c:v>5.9260000000000002</c:v>
                </c:pt>
                <c:pt idx="4">
                  <c:v>12.013999999999999</c:v>
                </c:pt>
                <c:pt idx="5">
                  <c:v>13.412000000000001</c:v>
                </c:pt>
                <c:pt idx="6">
                  <c:v>4.2850000000000001</c:v>
                </c:pt>
                <c:pt idx="7">
                  <c:v>16.988</c:v>
                </c:pt>
                <c:pt idx="8">
                  <c:v>7.1790000000000003</c:v>
                </c:pt>
                <c:pt idx="9">
                  <c:v>7.407</c:v>
                </c:pt>
                <c:pt idx="10">
                  <c:v>14.569000000000001</c:v>
                </c:pt>
                <c:pt idx="11">
                  <c:v>2.35</c:v>
                </c:pt>
                <c:pt idx="12">
                  <c:v>5.6619999999999999</c:v>
                </c:pt>
                <c:pt idx="13">
                  <c:v>4.6120000000000001</c:v>
                </c:pt>
                <c:pt idx="14">
                  <c:v>14.446</c:v>
                </c:pt>
                <c:pt idx="15">
                  <c:v>8.8260000000000005</c:v>
                </c:pt>
                <c:pt idx="16">
                  <c:v>1.982</c:v>
                </c:pt>
                <c:pt idx="17">
                  <c:v>6.6609999999999996</c:v>
                </c:pt>
                <c:pt idx="18">
                  <c:v>8.4149999999999991</c:v>
                </c:pt>
                <c:pt idx="19">
                  <c:v>4.2149999999999999</c:v>
                </c:pt>
                <c:pt idx="20">
                  <c:v>6.7690000000000001</c:v>
                </c:pt>
                <c:pt idx="21">
                  <c:v>12.151999999999999</c:v>
                </c:pt>
                <c:pt idx="22">
                  <c:v>6.0060000000000002</c:v>
                </c:pt>
                <c:pt idx="23">
                  <c:v>9.5779999999999994</c:v>
                </c:pt>
                <c:pt idx="24">
                  <c:v>9.8030000000000008</c:v>
                </c:pt>
                <c:pt idx="25">
                  <c:v>12.217000000000001</c:v>
                </c:pt>
                <c:pt idx="26">
                  <c:v>21.757999999999999</c:v>
                </c:pt>
                <c:pt idx="27">
                  <c:v>14.773</c:v>
                </c:pt>
                <c:pt idx="28">
                  <c:v>25.988</c:v>
                </c:pt>
                <c:pt idx="29">
                  <c:v>14.276999999999999</c:v>
                </c:pt>
                <c:pt idx="30">
                  <c:v>15.739000000000001</c:v>
                </c:pt>
                <c:pt idx="31">
                  <c:v>3.1190000000000002</c:v>
                </c:pt>
                <c:pt idx="32">
                  <c:v>7.1829999999999998</c:v>
                </c:pt>
                <c:pt idx="33">
                  <c:v>12.743</c:v>
                </c:pt>
                <c:pt idx="34">
                  <c:v>13.167999999999999</c:v>
                </c:pt>
                <c:pt idx="35">
                  <c:v>17.183</c:v>
                </c:pt>
                <c:pt idx="36">
                  <c:v>26.225999999999999</c:v>
                </c:pt>
                <c:pt idx="37">
                  <c:v>21.329000000000001</c:v>
                </c:pt>
                <c:pt idx="38">
                  <c:v>13.824</c:v>
                </c:pt>
                <c:pt idx="39">
                  <c:v>6.923</c:v>
                </c:pt>
                <c:pt idx="40">
                  <c:v>1.7490000000000001</c:v>
                </c:pt>
                <c:pt idx="41">
                  <c:v>5.0259999999999998</c:v>
                </c:pt>
                <c:pt idx="42">
                  <c:v>29.853000000000002</c:v>
                </c:pt>
                <c:pt idx="43">
                  <c:v>10.047000000000001</c:v>
                </c:pt>
                <c:pt idx="44">
                  <c:v>6.7910000000000004</c:v>
                </c:pt>
                <c:pt idx="45">
                  <c:v>11.236000000000001</c:v>
                </c:pt>
                <c:pt idx="46">
                  <c:v>4.01</c:v>
                </c:pt>
                <c:pt idx="47">
                  <c:v>18.079000000000001</c:v>
                </c:pt>
              </c:numCache>
            </c:numRef>
          </c:xVal>
          <c:yVal>
            <c:numRef>
              <c:f>'Fold change'!$AW$2:$AW$49</c:f>
              <c:numCache>
                <c:formatCode>General</c:formatCode>
                <c:ptCount val="48"/>
                <c:pt idx="0">
                  <c:v>13.451000000000001</c:v>
                </c:pt>
                <c:pt idx="1">
                  <c:v>17.048999999999999</c:v>
                </c:pt>
                <c:pt idx="2">
                  <c:v>5.7519999999999998</c:v>
                </c:pt>
                <c:pt idx="3">
                  <c:v>8.8520000000000003</c:v>
                </c:pt>
                <c:pt idx="4">
                  <c:v>25.164999999999999</c:v>
                </c:pt>
                <c:pt idx="5">
                  <c:v>20.984999999999999</c:v>
                </c:pt>
                <c:pt idx="6">
                  <c:v>14.117000000000001</c:v>
                </c:pt>
                <c:pt idx="7">
                  <c:v>34.567999999999998</c:v>
                </c:pt>
                <c:pt idx="8">
                  <c:v>7.6589999999999998</c:v>
                </c:pt>
                <c:pt idx="9">
                  <c:v>10.532999999999999</c:v>
                </c:pt>
                <c:pt idx="10">
                  <c:v>11.425000000000001</c:v>
                </c:pt>
                <c:pt idx="11">
                  <c:v>2.153</c:v>
                </c:pt>
                <c:pt idx="12">
                  <c:v>41.878999999999998</c:v>
                </c:pt>
                <c:pt idx="13">
                  <c:v>13.068</c:v>
                </c:pt>
                <c:pt idx="14">
                  <c:v>18.331</c:v>
                </c:pt>
                <c:pt idx="15">
                  <c:v>9.6829999999999998</c:v>
                </c:pt>
                <c:pt idx="16">
                  <c:v>18.314</c:v>
                </c:pt>
                <c:pt idx="17">
                  <c:v>15.454000000000001</c:v>
                </c:pt>
                <c:pt idx="18">
                  <c:v>15.067</c:v>
                </c:pt>
                <c:pt idx="19">
                  <c:v>6.5430000000000001</c:v>
                </c:pt>
                <c:pt idx="20">
                  <c:v>6.5119999999999996</c:v>
                </c:pt>
                <c:pt idx="21">
                  <c:v>28.425000000000001</c:v>
                </c:pt>
                <c:pt idx="22">
                  <c:v>9.0969999999999995</c:v>
                </c:pt>
                <c:pt idx="23">
                  <c:v>16.169</c:v>
                </c:pt>
                <c:pt idx="24">
                  <c:v>12.308</c:v>
                </c:pt>
                <c:pt idx="25">
                  <c:v>69.703000000000003</c:v>
                </c:pt>
                <c:pt idx="26">
                  <c:v>31.696999999999999</c:v>
                </c:pt>
                <c:pt idx="27">
                  <c:v>17.292000000000002</c:v>
                </c:pt>
                <c:pt idx="28">
                  <c:v>82.83</c:v>
                </c:pt>
                <c:pt idx="29">
                  <c:v>21.25</c:v>
                </c:pt>
                <c:pt idx="30">
                  <c:v>29.337</c:v>
                </c:pt>
                <c:pt idx="31">
                  <c:v>3.4809999999999999</c:v>
                </c:pt>
                <c:pt idx="32">
                  <c:v>8.0489999999999995</c:v>
                </c:pt>
                <c:pt idx="33">
                  <c:v>11.007</c:v>
                </c:pt>
                <c:pt idx="34">
                  <c:v>30.855</c:v>
                </c:pt>
                <c:pt idx="35">
                  <c:v>42.098999999999997</c:v>
                </c:pt>
                <c:pt idx="36">
                  <c:v>26.212</c:v>
                </c:pt>
                <c:pt idx="37">
                  <c:v>20.875</c:v>
                </c:pt>
                <c:pt idx="38">
                  <c:v>24.251999999999999</c:v>
                </c:pt>
                <c:pt idx="39">
                  <c:v>16.725999999999999</c:v>
                </c:pt>
                <c:pt idx="40">
                  <c:v>3.758</c:v>
                </c:pt>
                <c:pt idx="41">
                  <c:v>7.2709999999999999</c:v>
                </c:pt>
                <c:pt idx="42">
                  <c:v>18.138999999999999</c:v>
                </c:pt>
                <c:pt idx="43">
                  <c:v>12.727</c:v>
                </c:pt>
                <c:pt idx="44">
                  <c:v>16.954999999999998</c:v>
                </c:pt>
                <c:pt idx="45">
                  <c:v>190.619</c:v>
                </c:pt>
                <c:pt idx="46">
                  <c:v>52.283000000000001</c:v>
                </c:pt>
                <c:pt idx="47">
                  <c:v>35.643000000000001</c:v>
                </c:pt>
              </c:numCache>
            </c:numRef>
          </c:yVal>
          <c:smooth val="0"/>
          <c:extLst>
            <c:ext xmlns:c16="http://schemas.microsoft.com/office/drawing/2014/chart" uri="{C3380CC4-5D6E-409C-BE32-E72D297353CC}">
              <c16:uniqueId val="{00000000-1DA5-4144-B017-AB7B553C8A80}"/>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6</c:f>
              <c:numCache>
                <c:formatCode>General</c:formatCode>
                <c:ptCount val="5"/>
                <c:pt idx="0">
                  <c:v>0.1</c:v>
                </c:pt>
                <c:pt idx="1">
                  <c:v>1</c:v>
                </c:pt>
                <c:pt idx="2" formatCode="#,##0">
                  <c:v>10</c:v>
                </c:pt>
                <c:pt idx="3" formatCode="#,##0">
                  <c:v>100</c:v>
                </c:pt>
                <c:pt idx="4">
                  <c:v>1000</c:v>
                </c:pt>
              </c:numCache>
            </c:numRef>
          </c:xVal>
          <c:yVal>
            <c:numRef>
              <c:f>'Fold change'!$C$2:$C$6</c:f>
              <c:numCache>
                <c:formatCode>#,##0</c:formatCode>
                <c:ptCount val="5"/>
                <c:pt idx="0" formatCode="General">
                  <c:v>0.1</c:v>
                </c:pt>
                <c:pt idx="1">
                  <c:v>1</c:v>
                </c:pt>
                <c:pt idx="2">
                  <c:v>10</c:v>
                </c:pt>
                <c:pt idx="3">
                  <c:v>100</c:v>
                </c:pt>
                <c:pt idx="4" formatCode="General">
                  <c:v>1000</c:v>
                </c:pt>
              </c:numCache>
            </c:numRef>
          </c:yVal>
          <c:smooth val="0"/>
          <c:extLst>
            <c:ext xmlns:c16="http://schemas.microsoft.com/office/drawing/2014/chart" uri="{C3380CC4-5D6E-409C-BE32-E72D297353CC}">
              <c16:uniqueId val="{00000002-1DA5-4144-B017-AB7B553C8A80}"/>
            </c:ext>
          </c:extLst>
        </c:ser>
        <c:dLbls>
          <c:showLegendKey val="0"/>
          <c:showVal val="0"/>
          <c:showCatName val="0"/>
          <c:showSerName val="0"/>
          <c:showPercent val="0"/>
          <c:showBubbleSize val="0"/>
        </c:dLbls>
        <c:axId val="134456832"/>
        <c:axId val="134458752"/>
      </c:scatterChart>
      <c:valAx>
        <c:axId val="134456832"/>
        <c:scaling>
          <c:logBase val="10"/>
          <c:orientation val="minMax"/>
          <c:max val="1000"/>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4458752"/>
        <c:crossesAt val="0.1"/>
        <c:crossBetween val="midCat"/>
      </c:valAx>
      <c:valAx>
        <c:axId val="134458752"/>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4456832"/>
        <c:crossesAt val="0.1"/>
        <c:crossBetween val="midCat"/>
      </c:valAx>
    </c:plotArea>
    <c:plotVisOnly val="1"/>
    <c:dispBlanksAs val="gap"/>
    <c:showDLblsOverMax val="0"/>
  </c:chart>
  <c:spPr>
    <a:ln>
      <a:noFill/>
    </a:ln>
  </c:sp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19F</a:t>
            </a:r>
          </a:p>
        </c:rich>
      </c:tx>
      <c:overlay val="0"/>
    </c:title>
    <c:autoTitleDeleted val="0"/>
    <c:plotArea>
      <c:layout/>
      <c:scatterChart>
        <c:scatterStyle val="lineMarker"/>
        <c:varyColors val="0"/>
        <c:ser>
          <c:idx val="0"/>
          <c:order val="0"/>
          <c:tx>
            <c:strRef>
              <c:f>'Fold change'!$AZ$1</c:f>
              <c:strCache>
                <c:ptCount val="1"/>
                <c:pt idx="0">
                  <c:v>S19F_1</c:v>
                </c:pt>
              </c:strCache>
            </c:strRef>
          </c:tx>
          <c:spPr>
            <a:ln w="28575">
              <a:noFill/>
            </a:ln>
          </c:spPr>
          <c:xVal>
            <c:numRef>
              <c:f>'Fold change'!$AZ$2:$AZ$49</c:f>
              <c:numCache>
                <c:formatCode>General</c:formatCode>
                <c:ptCount val="48"/>
                <c:pt idx="0">
                  <c:v>12.249000000000001</c:v>
                </c:pt>
                <c:pt idx="1">
                  <c:v>13.147</c:v>
                </c:pt>
                <c:pt idx="2">
                  <c:v>3.786</c:v>
                </c:pt>
                <c:pt idx="3">
                  <c:v>4.8869999999999996</c:v>
                </c:pt>
                <c:pt idx="4">
                  <c:v>9.9649999999999999</c:v>
                </c:pt>
                <c:pt idx="5">
                  <c:v>12.15</c:v>
                </c:pt>
                <c:pt idx="6">
                  <c:v>8.1170000000000009</c:v>
                </c:pt>
                <c:pt idx="7">
                  <c:v>23.809000000000001</c:v>
                </c:pt>
                <c:pt idx="8">
                  <c:v>6.5030000000000001</c:v>
                </c:pt>
                <c:pt idx="9">
                  <c:v>9.6470000000000002</c:v>
                </c:pt>
                <c:pt idx="10">
                  <c:v>23.263999999999999</c:v>
                </c:pt>
                <c:pt idx="11">
                  <c:v>5.9960000000000004</c:v>
                </c:pt>
                <c:pt idx="12">
                  <c:v>7.2149999999999999</c:v>
                </c:pt>
                <c:pt idx="13">
                  <c:v>4.0199999999999996</c:v>
                </c:pt>
                <c:pt idx="14">
                  <c:v>15.304</c:v>
                </c:pt>
                <c:pt idx="15">
                  <c:v>10.564</c:v>
                </c:pt>
                <c:pt idx="16">
                  <c:v>2.1269999999999998</c:v>
                </c:pt>
                <c:pt idx="17">
                  <c:v>8.1159999999999997</c:v>
                </c:pt>
                <c:pt idx="18">
                  <c:v>3.22</c:v>
                </c:pt>
                <c:pt idx="19">
                  <c:v>4.3680000000000003</c:v>
                </c:pt>
                <c:pt idx="20">
                  <c:v>6.1059999999999999</c:v>
                </c:pt>
                <c:pt idx="21">
                  <c:v>8.9659999999999993</c:v>
                </c:pt>
                <c:pt idx="22">
                  <c:v>6.6390000000000002</c:v>
                </c:pt>
                <c:pt idx="23">
                  <c:v>9.3710000000000004</c:v>
                </c:pt>
                <c:pt idx="24">
                  <c:v>6.1740000000000004</c:v>
                </c:pt>
                <c:pt idx="25">
                  <c:v>7.18</c:v>
                </c:pt>
                <c:pt idx="26">
                  <c:v>28.074999999999999</c:v>
                </c:pt>
                <c:pt idx="27">
                  <c:v>16.388999999999999</c:v>
                </c:pt>
                <c:pt idx="28">
                  <c:v>32.061</c:v>
                </c:pt>
                <c:pt idx="29">
                  <c:v>13.406000000000001</c:v>
                </c:pt>
                <c:pt idx="30">
                  <c:v>13.242000000000001</c:v>
                </c:pt>
                <c:pt idx="31">
                  <c:v>2.9580000000000002</c:v>
                </c:pt>
                <c:pt idx="32">
                  <c:v>10.273999999999999</c:v>
                </c:pt>
                <c:pt idx="33">
                  <c:v>9.7319999999999993</c:v>
                </c:pt>
                <c:pt idx="34">
                  <c:v>22.417999999999999</c:v>
                </c:pt>
                <c:pt idx="35">
                  <c:v>17.495000000000001</c:v>
                </c:pt>
                <c:pt idx="36">
                  <c:v>38.131</c:v>
                </c:pt>
                <c:pt idx="37">
                  <c:v>26.866</c:v>
                </c:pt>
                <c:pt idx="38">
                  <c:v>17.346</c:v>
                </c:pt>
                <c:pt idx="39">
                  <c:v>3.327</c:v>
                </c:pt>
                <c:pt idx="40">
                  <c:v>2.4820000000000002</c:v>
                </c:pt>
                <c:pt idx="41">
                  <c:v>3.6789999999999998</c:v>
                </c:pt>
                <c:pt idx="42">
                  <c:v>12.849</c:v>
                </c:pt>
                <c:pt idx="43">
                  <c:v>13.19</c:v>
                </c:pt>
                <c:pt idx="44">
                  <c:v>8.4969999999999999</c:v>
                </c:pt>
                <c:pt idx="45">
                  <c:v>13.37</c:v>
                </c:pt>
                <c:pt idx="46">
                  <c:v>3.5329999999999999</c:v>
                </c:pt>
                <c:pt idx="47">
                  <c:v>19.645</c:v>
                </c:pt>
              </c:numCache>
            </c:numRef>
          </c:xVal>
          <c:yVal>
            <c:numRef>
              <c:f>'Fold change'!$BA$2:$BA$49</c:f>
              <c:numCache>
                <c:formatCode>General</c:formatCode>
                <c:ptCount val="48"/>
                <c:pt idx="0">
                  <c:v>20.777000000000001</c:v>
                </c:pt>
                <c:pt idx="1">
                  <c:v>31.936</c:v>
                </c:pt>
                <c:pt idx="2">
                  <c:v>43.720999999999997</c:v>
                </c:pt>
                <c:pt idx="3">
                  <c:v>8.6739999999999995</c:v>
                </c:pt>
                <c:pt idx="4">
                  <c:v>14.135999999999999</c:v>
                </c:pt>
                <c:pt idx="5">
                  <c:v>14.545999999999999</c:v>
                </c:pt>
                <c:pt idx="6">
                  <c:v>12.521000000000001</c:v>
                </c:pt>
                <c:pt idx="7">
                  <c:v>42.03</c:v>
                </c:pt>
                <c:pt idx="8">
                  <c:v>6.9560000000000004</c:v>
                </c:pt>
                <c:pt idx="9">
                  <c:v>17.286000000000001</c:v>
                </c:pt>
                <c:pt idx="10">
                  <c:v>23.167000000000002</c:v>
                </c:pt>
                <c:pt idx="11">
                  <c:v>11.788</c:v>
                </c:pt>
                <c:pt idx="12">
                  <c:v>38.219000000000001</c:v>
                </c:pt>
                <c:pt idx="13">
                  <c:v>14.246</c:v>
                </c:pt>
                <c:pt idx="14">
                  <c:v>12.244999999999999</c:v>
                </c:pt>
                <c:pt idx="15">
                  <c:v>11.476000000000001</c:v>
                </c:pt>
                <c:pt idx="16">
                  <c:v>19.172999999999998</c:v>
                </c:pt>
                <c:pt idx="17">
                  <c:v>20.228000000000002</c:v>
                </c:pt>
                <c:pt idx="18">
                  <c:v>4.6420000000000003</c:v>
                </c:pt>
                <c:pt idx="19">
                  <c:v>5.3680000000000003</c:v>
                </c:pt>
                <c:pt idx="20">
                  <c:v>5.5190000000000001</c:v>
                </c:pt>
                <c:pt idx="21">
                  <c:v>11.382999999999999</c:v>
                </c:pt>
                <c:pt idx="22">
                  <c:v>17.041</c:v>
                </c:pt>
                <c:pt idx="23">
                  <c:v>17.997</c:v>
                </c:pt>
                <c:pt idx="24">
                  <c:v>8.3360000000000003</c:v>
                </c:pt>
                <c:pt idx="25">
                  <c:v>32.652000000000001</c:v>
                </c:pt>
                <c:pt idx="26">
                  <c:v>25.655999999999999</c:v>
                </c:pt>
                <c:pt idx="27">
                  <c:v>17.754000000000001</c:v>
                </c:pt>
                <c:pt idx="28">
                  <c:v>55.777000000000001</c:v>
                </c:pt>
                <c:pt idx="29">
                  <c:v>17.004999999999999</c:v>
                </c:pt>
                <c:pt idx="30">
                  <c:v>29.542000000000002</c:v>
                </c:pt>
                <c:pt idx="31">
                  <c:v>10.513</c:v>
                </c:pt>
                <c:pt idx="32">
                  <c:v>8.8789999999999996</c:v>
                </c:pt>
                <c:pt idx="33">
                  <c:v>10.24</c:v>
                </c:pt>
                <c:pt idx="34">
                  <c:v>44.646999999999998</c:v>
                </c:pt>
                <c:pt idx="35">
                  <c:v>68.010000000000005</c:v>
                </c:pt>
                <c:pt idx="36">
                  <c:v>34.979999999999997</c:v>
                </c:pt>
                <c:pt idx="37">
                  <c:v>33.558999999999997</c:v>
                </c:pt>
                <c:pt idx="38">
                  <c:v>24.337</c:v>
                </c:pt>
                <c:pt idx="39">
                  <c:v>11.141999999999999</c:v>
                </c:pt>
                <c:pt idx="40">
                  <c:v>4.1980000000000004</c:v>
                </c:pt>
                <c:pt idx="41">
                  <c:v>5.75</c:v>
                </c:pt>
                <c:pt idx="42">
                  <c:v>12.589</c:v>
                </c:pt>
                <c:pt idx="43">
                  <c:v>15.055999999999999</c:v>
                </c:pt>
                <c:pt idx="44">
                  <c:v>30.722999999999999</c:v>
                </c:pt>
                <c:pt idx="45">
                  <c:v>133.023</c:v>
                </c:pt>
                <c:pt idx="46">
                  <c:v>32.634999999999998</c:v>
                </c:pt>
                <c:pt idx="47">
                  <c:v>25.681000000000001</c:v>
                </c:pt>
              </c:numCache>
            </c:numRef>
          </c:yVal>
          <c:smooth val="0"/>
          <c:extLst>
            <c:ext xmlns:c16="http://schemas.microsoft.com/office/drawing/2014/chart" uri="{C3380CC4-5D6E-409C-BE32-E72D297353CC}">
              <c16:uniqueId val="{00000000-F67F-4899-B099-069127B8A337}"/>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6</c:f>
              <c:numCache>
                <c:formatCode>General</c:formatCode>
                <c:ptCount val="5"/>
                <c:pt idx="0">
                  <c:v>0.1</c:v>
                </c:pt>
                <c:pt idx="1">
                  <c:v>1</c:v>
                </c:pt>
                <c:pt idx="2" formatCode="#,##0">
                  <c:v>10</c:v>
                </c:pt>
                <c:pt idx="3" formatCode="#,##0">
                  <c:v>100</c:v>
                </c:pt>
                <c:pt idx="4">
                  <c:v>1000</c:v>
                </c:pt>
              </c:numCache>
            </c:numRef>
          </c:xVal>
          <c:yVal>
            <c:numRef>
              <c:f>'Fold change'!$C$2:$C$6</c:f>
              <c:numCache>
                <c:formatCode>#,##0</c:formatCode>
                <c:ptCount val="5"/>
                <c:pt idx="0" formatCode="General">
                  <c:v>0.1</c:v>
                </c:pt>
                <c:pt idx="1">
                  <c:v>1</c:v>
                </c:pt>
                <c:pt idx="2">
                  <c:v>10</c:v>
                </c:pt>
                <c:pt idx="3">
                  <c:v>100</c:v>
                </c:pt>
                <c:pt idx="4" formatCode="General">
                  <c:v>1000</c:v>
                </c:pt>
              </c:numCache>
            </c:numRef>
          </c:yVal>
          <c:smooth val="0"/>
          <c:extLst>
            <c:ext xmlns:c16="http://schemas.microsoft.com/office/drawing/2014/chart" uri="{C3380CC4-5D6E-409C-BE32-E72D297353CC}">
              <c16:uniqueId val="{00000002-F67F-4899-B099-069127B8A337}"/>
            </c:ext>
          </c:extLst>
        </c:ser>
        <c:dLbls>
          <c:showLegendKey val="0"/>
          <c:showVal val="0"/>
          <c:showCatName val="0"/>
          <c:showSerName val="0"/>
          <c:showPercent val="0"/>
          <c:showBubbleSize val="0"/>
        </c:dLbls>
        <c:axId val="134485888"/>
        <c:axId val="134500352"/>
      </c:scatterChart>
      <c:valAx>
        <c:axId val="134485888"/>
        <c:scaling>
          <c:logBase val="10"/>
          <c:orientation val="minMax"/>
          <c:max val="1000"/>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4500352"/>
        <c:crossesAt val="0.1"/>
        <c:crossBetween val="midCat"/>
      </c:valAx>
      <c:valAx>
        <c:axId val="134500352"/>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4485888"/>
        <c:crossesAt val="0.1"/>
        <c:crossBetween val="midCat"/>
      </c:valAx>
    </c:plotArea>
    <c:plotVisOnly val="1"/>
    <c:dispBlanksAs val="gap"/>
    <c:showDLblsOverMax val="0"/>
  </c:chart>
  <c:spPr>
    <a:ln>
      <a:noFill/>
    </a:ln>
  </c:sp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23F</a:t>
            </a:r>
          </a:p>
        </c:rich>
      </c:tx>
      <c:overlay val="0"/>
    </c:title>
    <c:autoTitleDeleted val="0"/>
    <c:plotArea>
      <c:layout/>
      <c:scatterChart>
        <c:scatterStyle val="lineMarker"/>
        <c:varyColors val="0"/>
        <c:ser>
          <c:idx val="0"/>
          <c:order val="0"/>
          <c:tx>
            <c:strRef>
              <c:f>'Fold change'!$BD$1</c:f>
              <c:strCache>
                <c:ptCount val="1"/>
                <c:pt idx="0">
                  <c:v>S23F_1</c:v>
                </c:pt>
              </c:strCache>
            </c:strRef>
          </c:tx>
          <c:spPr>
            <a:ln w="28575">
              <a:noFill/>
            </a:ln>
          </c:spPr>
          <c:xVal>
            <c:numRef>
              <c:f>'Fold change'!$BD$2:$BD$49</c:f>
              <c:numCache>
                <c:formatCode>General</c:formatCode>
                <c:ptCount val="48"/>
                <c:pt idx="0">
                  <c:v>2.7469999999999999</c:v>
                </c:pt>
                <c:pt idx="1">
                  <c:v>4.6639999999999997</c:v>
                </c:pt>
                <c:pt idx="2">
                  <c:v>2.5499999999999998</c:v>
                </c:pt>
                <c:pt idx="3">
                  <c:v>6.851</c:v>
                </c:pt>
                <c:pt idx="4">
                  <c:v>2.7429999999999999</c:v>
                </c:pt>
                <c:pt idx="5">
                  <c:v>2.0110000000000001</c:v>
                </c:pt>
                <c:pt idx="6">
                  <c:v>2.9319999999999999</c:v>
                </c:pt>
                <c:pt idx="7">
                  <c:v>1.877</c:v>
                </c:pt>
                <c:pt idx="8">
                  <c:v>2.302</c:v>
                </c:pt>
                <c:pt idx="9">
                  <c:v>3.117</c:v>
                </c:pt>
                <c:pt idx="10">
                  <c:v>10.206</c:v>
                </c:pt>
                <c:pt idx="11">
                  <c:v>1.7170000000000001</c:v>
                </c:pt>
                <c:pt idx="12">
                  <c:v>15.867000000000001</c:v>
                </c:pt>
                <c:pt idx="13">
                  <c:v>1.9570000000000001</c:v>
                </c:pt>
                <c:pt idx="14">
                  <c:v>5.5250000000000004</c:v>
                </c:pt>
                <c:pt idx="15">
                  <c:v>6.0149999999999997</c:v>
                </c:pt>
                <c:pt idx="16">
                  <c:v>1.4630000000000001</c:v>
                </c:pt>
                <c:pt idx="17">
                  <c:v>1.758</c:v>
                </c:pt>
                <c:pt idx="18">
                  <c:v>0.751</c:v>
                </c:pt>
                <c:pt idx="19">
                  <c:v>0.97</c:v>
                </c:pt>
                <c:pt idx="20">
                  <c:v>2.3940000000000001</c:v>
                </c:pt>
                <c:pt idx="21">
                  <c:v>4.1269999999999998</c:v>
                </c:pt>
                <c:pt idx="22">
                  <c:v>1.6459999999999999</c:v>
                </c:pt>
                <c:pt idx="23">
                  <c:v>3.5369999999999999</c:v>
                </c:pt>
                <c:pt idx="24">
                  <c:v>4.407</c:v>
                </c:pt>
                <c:pt idx="25">
                  <c:v>12.544</c:v>
                </c:pt>
                <c:pt idx="26">
                  <c:v>8.8059999999999992</c:v>
                </c:pt>
                <c:pt idx="27">
                  <c:v>7.29</c:v>
                </c:pt>
                <c:pt idx="28">
                  <c:v>11.6</c:v>
                </c:pt>
                <c:pt idx="29">
                  <c:v>6.8760000000000003</c:v>
                </c:pt>
                <c:pt idx="30">
                  <c:v>13.162000000000001</c:v>
                </c:pt>
                <c:pt idx="31">
                  <c:v>0.85899999999999999</c:v>
                </c:pt>
                <c:pt idx="32">
                  <c:v>5.0359999999999996</c:v>
                </c:pt>
                <c:pt idx="33">
                  <c:v>6.8310000000000004</c:v>
                </c:pt>
                <c:pt idx="34">
                  <c:v>7.3319999999999999</c:v>
                </c:pt>
                <c:pt idx="35">
                  <c:v>11.172000000000001</c:v>
                </c:pt>
                <c:pt idx="36">
                  <c:v>14.194000000000001</c:v>
                </c:pt>
                <c:pt idx="37">
                  <c:v>12.318</c:v>
                </c:pt>
                <c:pt idx="38">
                  <c:v>6.1319999999999997</c:v>
                </c:pt>
                <c:pt idx="39">
                  <c:v>1.83</c:v>
                </c:pt>
                <c:pt idx="40">
                  <c:v>0.61599999999999999</c:v>
                </c:pt>
                <c:pt idx="41">
                  <c:v>1.6879999999999999</c:v>
                </c:pt>
                <c:pt idx="42">
                  <c:v>5.468</c:v>
                </c:pt>
                <c:pt idx="43">
                  <c:v>4.96</c:v>
                </c:pt>
                <c:pt idx="44">
                  <c:v>3.7519999999999998</c:v>
                </c:pt>
                <c:pt idx="45">
                  <c:v>4.1639999999999997</c:v>
                </c:pt>
                <c:pt idx="46">
                  <c:v>2.4</c:v>
                </c:pt>
                <c:pt idx="47">
                  <c:v>6.8079999999999998</c:v>
                </c:pt>
              </c:numCache>
            </c:numRef>
          </c:xVal>
          <c:yVal>
            <c:numRef>
              <c:f>'Fold change'!$BE$2:$BE$49</c:f>
              <c:numCache>
                <c:formatCode>General</c:formatCode>
                <c:ptCount val="48"/>
                <c:pt idx="0">
                  <c:v>36.353000000000002</c:v>
                </c:pt>
                <c:pt idx="1">
                  <c:v>31.052</c:v>
                </c:pt>
                <c:pt idx="2">
                  <c:v>14.569000000000001</c:v>
                </c:pt>
                <c:pt idx="3">
                  <c:v>13.7</c:v>
                </c:pt>
                <c:pt idx="4">
                  <c:v>22.041</c:v>
                </c:pt>
                <c:pt idx="5">
                  <c:v>13.532</c:v>
                </c:pt>
                <c:pt idx="6">
                  <c:v>14.132</c:v>
                </c:pt>
                <c:pt idx="7">
                  <c:v>4.47</c:v>
                </c:pt>
                <c:pt idx="8">
                  <c:v>5.8310000000000004</c:v>
                </c:pt>
                <c:pt idx="9">
                  <c:v>5.4279999999999999</c:v>
                </c:pt>
                <c:pt idx="10">
                  <c:v>13.816000000000001</c:v>
                </c:pt>
                <c:pt idx="11">
                  <c:v>4.0380000000000003</c:v>
                </c:pt>
                <c:pt idx="12">
                  <c:v>12.992000000000001</c:v>
                </c:pt>
                <c:pt idx="13">
                  <c:v>9.4190000000000005</c:v>
                </c:pt>
                <c:pt idx="14">
                  <c:v>13.742000000000001</c:v>
                </c:pt>
                <c:pt idx="15">
                  <c:v>6.359</c:v>
                </c:pt>
                <c:pt idx="16">
                  <c:v>4.26</c:v>
                </c:pt>
                <c:pt idx="17">
                  <c:v>8.782</c:v>
                </c:pt>
                <c:pt idx="18">
                  <c:v>4.8079999999999998</c:v>
                </c:pt>
                <c:pt idx="19">
                  <c:v>7.9939999999999998</c:v>
                </c:pt>
                <c:pt idx="20">
                  <c:v>2.5720000000000001</c:v>
                </c:pt>
                <c:pt idx="21">
                  <c:v>59.264000000000003</c:v>
                </c:pt>
                <c:pt idx="22">
                  <c:v>5.6740000000000004</c:v>
                </c:pt>
                <c:pt idx="23">
                  <c:v>19.786999999999999</c:v>
                </c:pt>
                <c:pt idx="24">
                  <c:v>12.836</c:v>
                </c:pt>
                <c:pt idx="25">
                  <c:v>11.861000000000001</c:v>
                </c:pt>
                <c:pt idx="26">
                  <c:v>7.734</c:v>
                </c:pt>
                <c:pt idx="27">
                  <c:v>10.24</c:v>
                </c:pt>
                <c:pt idx="28">
                  <c:v>15.372</c:v>
                </c:pt>
                <c:pt idx="29">
                  <c:v>24.257999999999999</c:v>
                </c:pt>
                <c:pt idx="31">
                  <c:v>6.77</c:v>
                </c:pt>
                <c:pt idx="32">
                  <c:v>8.5670000000000002</c:v>
                </c:pt>
                <c:pt idx="33">
                  <c:v>5.9189999999999996</c:v>
                </c:pt>
                <c:pt idx="34">
                  <c:v>39.390999999999998</c:v>
                </c:pt>
                <c:pt idx="35">
                  <c:v>16.510000000000002</c:v>
                </c:pt>
                <c:pt idx="36">
                  <c:v>29.283000000000001</c:v>
                </c:pt>
                <c:pt idx="37">
                  <c:v>42.856000000000002</c:v>
                </c:pt>
                <c:pt idx="38">
                  <c:v>11.946999999999999</c:v>
                </c:pt>
                <c:pt idx="39">
                  <c:v>38.728000000000002</c:v>
                </c:pt>
                <c:pt idx="40">
                  <c:v>3.85</c:v>
                </c:pt>
                <c:pt idx="41">
                  <c:v>26.599</c:v>
                </c:pt>
                <c:pt idx="42">
                  <c:v>6.6109999999999998</c:v>
                </c:pt>
                <c:pt idx="43">
                  <c:v>18.231000000000002</c:v>
                </c:pt>
                <c:pt idx="44">
                  <c:v>7.4169999999999998</c:v>
                </c:pt>
                <c:pt idx="45">
                  <c:v>5.3849999999999998</c:v>
                </c:pt>
                <c:pt idx="46">
                  <c:v>22.334</c:v>
                </c:pt>
                <c:pt idx="47">
                  <c:v>12.153</c:v>
                </c:pt>
              </c:numCache>
            </c:numRef>
          </c:yVal>
          <c:smooth val="0"/>
          <c:extLst>
            <c:ext xmlns:c16="http://schemas.microsoft.com/office/drawing/2014/chart" uri="{C3380CC4-5D6E-409C-BE32-E72D297353CC}">
              <c16:uniqueId val="{00000000-CF55-497A-BF67-3E386281129A}"/>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CF55-497A-BF67-3E386281129A}"/>
            </c:ext>
          </c:extLst>
        </c:ser>
        <c:dLbls>
          <c:showLegendKey val="0"/>
          <c:showVal val="0"/>
          <c:showCatName val="0"/>
          <c:showSerName val="0"/>
          <c:showPercent val="0"/>
          <c:showBubbleSize val="0"/>
        </c:dLbls>
        <c:axId val="134516096"/>
        <c:axId val="134518272"/>
      </c:scatterChart>
      <c:valAx>
        <c:axId val="134516096"/>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4518272"/>
        <c:crossesAt val="0.1"/>
        <c:crossBetween val="midCat"/>
      </c:valAx>
      <c:valAx>
        <c:axId val="134518272"/>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4516096"/>
        <c:crossesAt val="0.1"/>
        <c:crossBetween val="midCat"/>
      </c:valAx>
    </c:plotArea>
    <c:plotVisOnly val="1"/>
    <c:dispBlanksAs val="gap"/>
    <c:showDLblsOverMax val="0"/>
  </c:chart>
  <c:spPr>
    <a:ln>
      <a:noFill/>
    </a:ln>
  </c:sp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title>
      <c:tx>
        <c:rich>
          <a:bodyPr/>
          <a:lstStyle/>
          <a:p>
            <a:pPr>
              <a:defRPr sz="1200"/>
            </a:pPr>
            <a:r>
              <a:rPr lang="en-US" sz="1200"/>
              <a:t>Serotype 2</a:t>
            </a:r>
          </a:p>
        </c:rich>
      </c:tx>
      <c:overlay val="0"/>
    </c:title>
    <c:autoTitleDeleted val="0"/>
    <c:plotArea>
      <c:layout/>
      <c:scatterChart>
        <c:scatterStyle val="lineMarker"/>
        <c:varyColors val="0"/>
        <c:ser>
          <c:idx val="0"/>
          <c:order val="0"/>
          <c:tx>
            <c:strRef>
              <c:f>'Fold change'!$H$1</c:f>
              <c:strCache>
                <c:ptCount val="1"/>
                <c:pt idx="0">
                  <c:v>S2_1</c:v>
                </c:pt>
              </c:strCache>
            </c:strRef>
          </c:tx>
          <c:spPr>
            <a:ln w="28575">
              <a:noFill/>
            </a:ln>
          </c:spPr>
          <c:xVal>
            <c:numRef>
              <c:f>'Fold change'!$H$2:$H$49</c:f>
              <c:numCache>
                <c:formatCode>General</c:formatCode>
                <c:ptCount val="48"/>
                <c:pt idx="0">
                  <c:v>2.66</c:v>
                </c:pt>
                <c:pt idx="1">
                  <c:v>3.0270000000000001</c:v>
                </c:pt>
                <c:pt idx="2">
                  <c:v>1.8520000000000001</c:v>
                </c:pt>
                <c:pt idx="3">
                  <c:v>1.4330000000000001</c:v>
                </c:pt>
                <c:pt idx="4">
                  <c:v>1.528</c:v>
                </c:pt>
                <c:pt idx="5">
                  <c:v>1.6519999999999999</c:v>
                </c:pt>
                <c:pt idx="6">
                  <c:v>4.0170000000000003</c:v>
                </c:pt>
                <c:pt idx="7">
                  <c:v>4.944</c:v>
                </c:pt>
                <c:pt idx="8">
                  <c:v>1.538</c:v>
                </c:pt>
                <c:pt idx="9">
                  <c:v>1.7310000000000001</c:v>
                </c:pt>
                <c:pt idx="10">
                  <c:v>5.851</c:v>
                </c:pt>
                <c:pt idx="11">
                  <c:v>2.2810000000000001</c:v>
                </c:pt>
                <c:pt idx="12">
                  <c:v>3.9460000000000002</c:v>
                </c:pt>
                <c:pt idx="13">
                  <c:v>2.1829999999999998</c:v>
                </c:pt>
                <c:pt idx="14">
                  <c:v>3.2770000000000001</c:v>
                </c:pt>
                <c:pt idx="15">
                  <c:v>6.5720000000000001</c:v>
                </c:pt>
                <c:pt idx="16">
                  <c:v>1.1519999999999999</c:v>
                </c:pt>
                <c:pt idx="17">
                  <c:v>1.5569999999999999</c:v>
                </c:pt>
                <c:pt idx="18">
                  <c:v>0.41099999999999998</c:v>
                </c:pt>
                <c:pt idx="19">
                  <c:v>0.44900000000000001</c:v>
                </c:pt>
                <c:pt idx="20">
                  <c:v>1.8919999999999999</c:v>
                </c:pt>
                <c:pt idx="21">
                  <c:v>3.472</c:v>
                </c:pt>
                <c:pt idx="22">
                  <c:v>0.36599999999999999</c:v>
                </c:pt>
                <c:pt idx="23">
                  <c:v>1.9790000000000001</c:v>
                </c:pt>
                <c:pt idx="24">
                  <c:v>3.226</c:v>
                </c:pt>
                <c:pt idx="25">
                  <c:v>2.956</c:v>
                </c:pt>
                <c:pt idx="26">
                  <c:v>8.3559999999999999</c:v>
                </c:pt>
                <c:pt idx="27">
                  <c:v>4.6870000000000003</c:v>
                </c:pt>
                <c:pt idx="28">
                  <c:v>8.6229999999999993</c:v>
                </c:pt>
                <c:pt idx="29">
                  <c:v>7.2839999999999998</c:v>
                </c:pt>
                <c:pt idx="30">
                  <c:v>5.24</c:v>
                </c:pt>
                <c:pt idx="31">
                  <c:v>0.42399999999999999</c:v>
                </c:pt>
                <c:pt idx="32">
                  <c:v>6.36</c:v>
                </c:pt>
                <c:pt idx="33">
                  <c:v>5.649</c:v>
                </c:pt>
                <c:pt idx="34">
                  <c:v>6.32</c:v>
                </c:pt>
                <c:pt idx="35">
                  <c:v>6.8630000000000004</c:v>
                </c:pt>
                <c:pt idx="36">
                  <c:v>23.934999999999999</c:v>
                </c:pt>
                <c:pt idx="37">
                  <c:v>14.843999999999999</c:v>
                </c:pt>
                <c:pt idx="38">
                  <c:v>10.391999999999999</c:v>
                </c:pt>
                <c:pt idx="39">
                  <c:v>2.3849999999999998</c:v>
                </c:pt>
                <c:pt idx="40">
                  <c:v>0.88</c:v>
                </c:pt>
                <c:pt idx="41">
                  <c:v>2.4729999999999999</c:v>
                </c:pt>
                <c:pt idx="42">
                  <c:v>5.3810000000000002</c:v>
                </c:pt>
                <c:pt idx="43">
                  <c:v>4.6150000000000002</c:v>
                </c:pt>
                <c:pt idx="44">
                  <c:v>1.67</c:v>
                </c:pt>
                <c:pt idx="45">
                  <c:v>2.3239999999999998</c:v>
                </c:pt>
                <c:pt idx="46">
                  <c:v>2.641</c:v>
                </c:pt>
                <c:pt idx="47">
                  <c:v>10.336</c:v>
                </c:pt>
              </c:numCache>
            </c:numRef>
          </c:xVal>
          <c:yVal>
            <c:numRef>
              <c:f>'Fold change'!$I$2:$I$49</c:f>
              <c:numCache>
                <c:formatCode>General</c:formatCode>
                <c:ptCount val="48"/>
                <c:pt idx="0">
                  <c:v>2.66</c:v>
                </c:pt>
                <c:pt idx="1">
                  <c:v>4.0910000000000002</c:v>
                </c:pt>
                <c:pt idx="2">
                  <c:v>1.236</c:v>
                </c:pt>
                <c:pt idx="3">
                  <c:v>1.3069999999999999</c:v>
                </c:pt>
                <c:pt idx="4">
                  <c:v>1.419</c:v>
                </c:pt>
                <c:pt idx="5">
                  <c:v>2.2890000000000001</c:v>
                </c:pt>
                <c:pt idx="6">
                  <c:v>4.6820000000000004</c:v>
                </c:pt>
                <c:pt idx="7">
                  <c:v>3.7370000000000001</c:v>
                </c:pt>
                <c:pt idx="8">
                  <c:v>1.6819999999999999</c:v>
                </c:pt>
                <c:pt idx="9">
                  <c:v>1.909</c:v>
                </c:pt>
                <c:pt idx="10">
                  <c:v>2.9889999999999999</c:v>
                </c:pt>
                <c:pt idx="11">
                  <c:v>1.6879999999999999</c:v>
                </c:pt>
                <c:pt idx="12">
                  <c:v>4.4960000000000004</c:v>
                </c:pt>
                <c:pt idx="13">
                  <c:v>5.63</c:v>
                </c:pt>
                <c:pt idx="14">
                  <c:v>2.6070000000000002</c:v>
                </c:pt>
                <c:pt idx="15">
                  <c:v>5.6020000000000003</c:v>
                </c:pt>
                <c:pt idx="16">
                  <c:v>2.4569999999999999</c:v>
                </c:pt>
                <c:pt idx="17">
                  <c:v>8.5809999999999995</c:v>
                </c:pt>
                <c:pt idx="18">
                  <c:v>0.67200000000000004</c:v>
                </c:pt>
                <c:pt idx="19">
                  <c:v>0.9</c:v>
                </c:pt>
                <c:pt idx="20">
                  <c:v>1.625</c:v>
                </c:pt>
                <c:pt idx="21">
                  <c:v>2.8650000000000002</c:v>
                </c:pt>
                <c:pt idx="22">
                  <c:v>0.246</c:v>
                </c:pt>
                <c:pt idx="23">
                  <c:v>1.804</c:v>
                </c:pt>
                <c:pt idx="24">
                  <c:v>3.0539999999999998</c:v>
                </c:pt>
                <c:pt idx="25">
                  <c:v>3.089</c:v>
                </c:pt>
                <c:pt idx="26">
                  <c:v>3.65</c:v>
                </c:pt>
                <c:pt idx="27">
                  <c:v>4.93</c:v>
                </c:pt>
                <c:pt idx="28">
                  <c:v>7.9</c:v>
                </c:pt>
                <c:pt idx="29">
                  <c:v>8.9320000000000004</c:v>
                </c:pt>
                <c:pt idx="30">
                  <c:v>6.9039999999999999</c:v>
                </c:pt>
                <c:pt idx="31">
                  <c:v>0.32200000000000001</c:v>
                </c:pt>
                <c:pt idx="32">
                  <c:v>5.4569999999999999</c:v>
                </c:pt>
                <c:pt idx="33">
                  <c:v>4.9180000000000001</c:v>
                </c:pt>
                <c:pt idx="34">
                  <c:v>8.984</c:v>
                </c:pt>
                <c:pt idx="35">
                  <c:v>8.2240000000000002</c:v>
                </c:pt>
                <c:pt idx="36">
                  <c:v>21.609000000000002</c:v>
                </c:pt>
                <c:pt idx="37">
                  <c:v>14.284000000000001</c:v>
                </c:pt>
                <c:pt idx="38">
                  <c:v>7.0869999999999997</c:v>
                </c:pt>
                <c:pt idx="39">
                  <c:v>2.6619999999999999</c:v>
                </c:pt>
                <c:pt idx="40">
                  <c:v>0.7</c:v>
                </c:pt>
                <c:pt idx="41">
                  <c:v>2.105</c:v>
                </c:pt>
                <c:pt idx="42">
                  <c:v>2.9660000000000002</c:v>
                </c:pt>
                <c:pt idx="43">
                  <c:v>3.427</c:v>
                </c:pt>
                <c:pt idx="44">
                  <c:v>2.57</c:v>
                </c:pt>
                <c:pt idx="45">
                  <c:v>2.58</c:v>
                </c:pt>
                <c:pt idx="46">
                  <c:v>4.9690000000000003</c:v>
                </c:pt>
                <c:pt idx="47">
                  <c:v>14.981999999999999</c:v>
                </c:pt>
              </c:numCache>
            </c:numRef>
          </c:yVal>
          <c:smooth val="0"/>
          <c:extLst>
            <c:ext xmlns:c16="http://schemas.microsoft.com/office/drawing/2014/chart" uri="{C3380CC4-5D6E-409C-BE32-E72D297353CC}">
              <c16:uniqueId val="{00000000-0675-4A08-B80A-768E8907CBFF}"/>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0675-4A08-B80A-768E8907CBFF}"/>
            </c:ext>
          </c:extLst>
        </c:ser>
        <c:dLbls>
          <c:showLegendKey val="0"/>
          <c:showVal val="0"/>
          <c:showCatName val="0"/>
          <c:showSerName val="0"/>
          <c:showPercent val="0"/>
          <c:showBubbleSize val="0"/>
        </c:dLbls>
        <c:axId val="118146560"/>
        <c:axId val="118148480"/>
      </c:scatterChart>
      <c:valAx>
        <c:axId val="118146560"/>
        <c:scaling>
          <c:logBase val="10"/>
          <c:orientation val="minMax"/>
          <c:min val="0.1"/>
        </c:scaling>
        <c:delete val="0"/>
        <c:axPos val="b"/>
        <c:title>
          <c:tx>
            <c:rich>
              <a:bodyPr/>
              <a:lstStyle/>
              <a:p>
                <a:pPr>
                  <a:defRPr/>
                </a:pPr>
                <a:r>
                  <a:rPr lang="en-US" dirty="0"/>
                  <a:t>Pre-PCV IgG titers (</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18148480"/>
        <c:crossesAt val="0.1"/>
        <c:crossBetween val="midCat"/>
      </c:valAx>
      <c:valAx>
        <c:axId val="118148480"/>
        <c:scaling>
          <c:logBase val="10"/>
          <c:orientation val="minMax"/>
        </c:scaling>
        <c:delete val="0"/>
        <c:axPos val="l"/>
        <c:majorGridlines/>
        <c:title>
          <c:tx>
            <c:rich>
              <a:bodyPr rot="-5400000" vert="horz"/>
              <a:lstStyle/>
              <a:p>
                <a:pPr>
                  <a:defRPr/>
                </a:pPr>
                <a:r>
                  <a:rPr lang="en-AU" dirty="0"/>
                  <a:t>Post-PCV  IgG (</a:t>
                </a:r>
                <a:r>
                  <a:rPr lang="en-US" sz="1000" b="1" i="0" u="none" strike="noStrike" baseline="0" dirty="0">
                    <a:effectLst/>
                  </a:rPr>
                  <a:t>µg/mL)</a:t>
                </a:r>
                <a:endParaRPr lang="en-AU" dirty="0"/>
              </a:p>
            </c:rich>
          </c:tx>
          <c:overlay val="0"/>
        </c:title>
        <c:numFmt formatCode="General" sourceLinked="1"/>
        <c:majorTickMark val="out"/>
        <c:minorTickMark val="out"/>
        <c:tickLblPos val="nextTo"/>
        <c:crossAx val="118146560"/>
        <c:crossesAt val="0.1"/>
        <c:crossBetween val="midCat"/>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3</a:t>
            </a:r>
          </a:p>
        </c:rich>
      </c:tx>
      <c:overlay val="0"/>
    </c:title>
    <c:autoTitleDeleted val="0"/>
    <c:plotArea>
      <c:layout/>
      <c:scatterChart>
        <c:scatterStyle val="lineMarker"/>
        <c:varyColors val="0"/>
        <c:ser>
          <c:idx val="0"/>
          <c:order val="0"/>
          <c:tx>
            <c:strRef>
              <c:f>'Fold change'!$L$1</c:f>
              <c:strCache>
                <c:ptCount val="1"/>
                <c:pt idx="0">
                  <c:v>S3_1</c:v>
                </c:pt>
              </c:strCache>
            </c:strRef>
          </c:tx>
          <c:spPr>
            <a:ln w="28575">
              <a:noFill/>
            </a:ln>
          </c:spPr>
          <c:xVal>
            <c:numRef>
              <c:f>'Fold change'!$L$2:$L$49</c:f>
              <c:numCache>
                <c:formatCode>General</c:formatCode>
                <c:ptCount val="48"/>
                <c:pt idx="0">
                  <c:v>0.189</c:v>
                </c:pt>
                <c:pt idx="1">
                  <c:v>0.88900000000000001</c:v>
                </c:pt>
                <c:pt idx="2">
                  <c:v>0.17599999999999999</c:v>
                </c:pt>
                <c:pt idx="3">
                  <c:v>0.27100000000000002</c:v>
                </c:pt>
                <c:pt idx="4">
                  <c:v>0.41599999999999998</c:v>
                </c:pt>
                <c:pt idx="5">
                  <c:v>0.33400000000000002</c:v>
                </c:pt>
                <c:pt idx="6">
                  <c:v>0.503</c:v>
                </c:pt>
                <c:pt idx="7">
                  <c:v>0.64600000000000002</c:v>
                </c:pt>
                <c:pt idx="8">
                  <c:v>0.51800000000000002</c:v>
                </c:pt>
                <c:pt idx="9">
                  <c:v>0.20699999999999999</c:v>
                </c:pt>
                <c:pt idx="10">
                  <c:v>0.432</c:v>
                </c:pt>
                <c:pt idx="11">
                  <c:v>0.504</c:v>
                </c:pt>
                <c:pt idx="12">
                  <c:v>0.26900000000000002</c:v>
                </c:pt>
                <c:pt idx="13">
                  <c:v>0.47499999999999998</c:v>
                </c:pt>
                <c:pt idx="14">
                  <c:v>0.28000000000000003</c:v>
                </c:pt>
                <c:pt idx="15">
                  <c:v>0.83599999999999997</c:v>
                </c:pt>
                <c:pt idx="16">
                  <c:v>0.32400000000000001</c:v>
                </c:pt>
                <c:pt idx="17">
                  <c:v>0.61299999999999999</c:v>
                </c:pt>
                <c:pt idx="18">
                  <c:v>0.15</c:v>
                </c:pt>
                <c:pt idx="19">
                  <c:v>0.32500000000000001</c:v>
                </c:pt>
                <c:pt idx="20">
                  <c:v>0.29099999999999998</c:v>
                </c:pt>
                <c:pt idx="21">
                  <c:v>0.38400000000000001</c:v>
                </c:pt>
                <c:pt idx="22">
                  <c:v>0.155</c:v>
                </c:pt>
                <c:pt idx="23">
                  <c:v>0.374</c:v>
                </c:pt>
                <c:pt idx="24">
                  <c:v>0.13700000000000001</c:v>
                </c:pt>
                <c:pt idx="25">
                  <c:v>0.374</c:v>
                </c:pt>
                <c:pt idx="26">
                  <c:v>0.39100000000000001</c:v>
                </c:pt>
                <c:pt idx="27">
                  <c:v>0.35799999999999998</c:v>
                </c:pt>
                <c:pt idx="28">
                  <c:v>2.3370000000000002</c:v>
                </c:pt>
                <c:pt idx="29">
                  <c:v>1.0229999999999999</c:v>
                </c:pt>
                <c:pt idx="30">
                  <c:v>1.7390000000000001</c:v>
                </c:pt>
                <c:pt idx="31">
                  <c:v>0.06</c:v>
                </c:pt>
                <c:pt idx="32">
                  <c:v>1.762</c:v>
                </c:pt>
                <c:pt idx="33">
                  <c:v>0.50800000000000001</c:v>
                </c:pt>
                <c:pt idx="34">
                  <c:v>1.149</c:v>
                </c:pt>
                <c:pt idx="35">
                  <c:v>0.997</c:v>
                </c:pt>
                <c:pt idx="36">
                  <c:v>3.5329999999999999</c:v>
                </c:pt>
                <c:pt idx="37">
                  <c:v>0.88900000000000001</c:v>
                </c:pt>
                <c:pt idx="38">
                  <c:v>1.5580000000000001</c:v>
                </c:pt>
                <c:pt idx="39">
                  <c:v>0.22700000000000001</c:v>
                </c:pt>
                <c:pt idx="40">
                  <c:v>8.5999999999999993E-2</c:v>
                </c:pt>
                <c:pt idx="41">
                  <c:v>0.34499999999999997</c:v>
                </c:pt>
                <c:pt idx="42">
                  <c:v>0.36</c:v>
                </c:pt>
                <c:pt idx="43">
                  <c:v>1.1220000000000001</c:v>
                </c:pt>
                <c:pt idx="44">
                  <c:v>0.38800000000000001</c:v>
                </c:pt>
                <c:pt idx="45">
                  <c:v>0.23799999999999999</c:v>
                </c:pt>
                <c:pt idx="46">
                  <c:v>0.23400000000000001</c:v>
                </c:pt>
                <c:pt idx="47">
                  <c:v>1.006</c:v>
                </c:pt>
              </c:numCache>
            </c:numRef>
          </c:xVal>
          <c:yVal>
            <c:numRef>
              <c:f>'Fold change'!$M$2:$M$49</c:f>
              <c:numCache>
                <c:formatCode>General</c:formatCode>
                <c:ptCount val="48"/>
                <c:pt idx="0">
                  <c:v>0.34399999999999997</c:v>
                </c:pt>
                <c:pt idx="1">
                  <c:v>1.891</c:v>
                </c:pt>
                <c:pt idx="2">
                  <c:v>0.15</c:v>
                </c:pt>
                <c:pt idx="3">
                  <c:v>0.22800000000000001</c:v>
                </c:pt>
                <c:pt idx="4">
                  <c:v>0.33100000000000002</c:v>
                </c:pt>
                <c:pt idx="5">
                  <c:v>0.49099999999999999</c:v>
                </c:pt>
                <c:pt idx="6">
                  <c:v>1.085</c:v>
                </c:pt>
                <c:pt idx="7">
                  <c:v>0.72899999999999998</c:v>
                </c:pt>
                <c:pt idx="8">
                  <c:v>0.56599999999999995</c:v>
                </c:pt>
                <c:pt idx="9">
                  <c:v>0.19700000000000001</c:v>
                </c:pt>
                <c:pt idx="10">
                  <c:v>0.34399999999999997</c:v>
                </c:pt>
                <c:pt idx="11">
                  <c:v>0.40200000000000002</c:v>
                </c:pt>
                <c:pt idx="12">
                  <c:v>0.309</c:v>
                </c:pt>
                <c:pt idx="13">
                  <c:v>1.3240000000000001</c:v>
                </c:pt>
                <c:pt idx="14">
                  <c:v>0.59599999999999997</c:v>
                </c:pt>
                <c:pt idx="15">
                  <c:v>0.83199999999999996</c:v>
                </c:pt>
                <c:pt idx="16">
                  <c:v>0.25</c:v>
                </c:pt>
                <c:pt idx="17">
                  <c:v>1.946</c:v>
                </c:pt>
                <c:pt idx="18">
                  <c:v>0.28799999999999998</c:v>
                </c:pt>
                <c:pt idx="19">
                  <c:v>0.41299999999999998</c:v>
                </c:pt>
                <c:pt idx="20">
                  <c:v>0.32500000000000001</c:v>
                </c:pt>
                <c:pt idx="21">
                  <c:v>0.63700000000000001</c:v>
                </c:pt>
                <c:pt idx="22">
                  <c:v>0.224</c:v>
                </c:pt>
                <c:pt idx="23">
                  <c:v>0.46800000000000003</c:v>
                </c:pt>
                <c:pt idx="24">
                  <c:v>0.159</c:v>
                </c:pt>
                <c:pt idx="25">
                  <c:v>0.36099999999999999</c:v>
                </c:pt>
                <c:pt idx="26">
                  <c:v>0.19900000000000001</c:v>
                </c:pt>
                <c:pt idx="27">
                  <c:v>0.22700000000000001</c:v>
                </c:pt>
                <c:pt idx="28">
                  <c:v>2.7080000000000002</c:v>
                </c:pt>
                <c:pt idx="29">
                  <c:v>0.871</c:v>
                </c:pt>
                <c:pt idx="30">
                  <c:v>7.24</c:v>
                </c:pt>
                <c:pt idx="31">
                  <c:v>0.20399999999999999</c:v>
                </c:pt>
                <c:pt idx="32">
                  <c:v>1.9770000000000001</c:v>
                </c:pt>
                <c:pt idx="33">
                  <c:v>0.59</c:v>
                </c:pt>
                <c:pt idx="34">
                  <c:v>1.8879999999999999</c:v>
                </c:pt>
                <c:pt idx="35">
                  <c:v>4.3140000000000001</c:v>
                </c:pt>
                <c:pt idx="36">
                  <c:v>4.1399999999999997</c:v>
                </c:pt>
                <c:pt idx="37">
                  <c:v>4.7519999999999998</c:v>
                </c:pt>
                <c:pt idx="38">
                  <c:v>2.0089999999999999</c:v>
                </c:pt>
                <c:pt idx="39">
                  <c:v>1.022</c:v>
                </c:pt>
                <c:pt idx="40">
                  <c:v>0.124</c:v>
                </c:pt>
                <c:pt idx="41">
                  <c:v>0.377</c:v>
                </c:pt>
                <c:pt idx="42">
                  <c:v>0.184</c:v>
                </c:pt>
                <c:pt idx="43">
                  <c:v>1.6870000000000001</c:v>
                </c:pt>
                <c:pt idx="44">
                  <c:v>1.3129999999999999</c:v>
                </c:pt>
                <c:pt idx="45">
                  <c:v>1.365</c:v>
                </c:pt>
                <c:pt idx="46">
                  <c:v>1.028</c:v>
                </c:pt>
                <c:pt idx="47">
                  <c:v>3.6749999999999998</c:v>
                </c:pt>
              </c:numCache>
            </c:numRef>
          </c:yVal>
          <c:smooth val="0"/>
          <c:extLst>
            <c:ext xmlns:c16="http://schemas.microsoft.com/office/drawing/2014/chart" uri="{C3380CC4-5D6E-409C-BE32-E72D297353CC}">
              <c16:uniqueId val="{00000000-A4CB-4F9C-8813-B39AE7100F90}"/>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A4CB-4F9C-8813-B39AE7100F90}"/>
            </c:ext>
          </c:extLst>
        </c:ser>
        <c:dLbls>
          <c:showLegendKey val="0"/>
          <c:showVal val="0"/>
          <c:showCatName val="0"/>
          <c:showSerName val="0"/>
          <c:showPercent val="0"/>
          <c:showBubbleSize val="0"/>
        </c:dLbls>
        <c:axId val="132208512"/>
        <c:axId val="132210688"/>
      </c:scatterChart>
      <c:valAx>
        <c:axId val="132208512"/>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r>
                  <a:rPr lang="en-US" dirty="0"/>
                  <a:t>)</a:t>
                </a:r>
              </a:p>
            </c:rich>
          </c:tx>
          <c:overlay val="0"/>
        </c:title>
        <c:numFmt formatCode="General" sourceLinked="1"/>
        <c:majorTickMark val="out"/>
        <c:minorTickMark val="out"/>
        <c:tickLblPos val="nextTo"/>
        <c:crossAx val="132210688"/>
        <c:crossesAt val="0.1"/>
        <c:crossBetween val="midCat"/>
      </c:valAx>
      <c:valAx>
        <c:axId val="132210688"/>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r>
                  <a:rPr lang="en-AU" sz="1100" baseline="0" dirty="0"/>
                  <a:t>)</a:t>
                </a:r>
                <a:endParaRPr lang="en-AU" sz="1100" dirty="0"/>
              </a:p>
            </c:rich>
          </c:tx>
          <c:overlay val="0"/>
        </c:title>
        <c:numFmt formatCode="General" sourceLinked="1"/>
        <c:majorTickMark val="out"/>
        <c:minorTickMark val="out"/>
        <c:tickLblPos val="nextTo"/>
        <c:crossAx val="132208512"/>
        <c:crossesAt val="0.1"/>
        <c:crossBetween val="midCat"/>
      </c:valAx>
    </c:plotArea>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4</a:t>
            </a:r>
          </a:p>
        </c:rich>
      </c:tx>
      <c:overlay val="0"/>
    </c:title>
    <c:autoTitleDeleted val="0"/>
    <c:plotArea>
      <c:layout/>
      <c:scatterChart>
        <c:scatterStyle val="lineMarker"/>
        <c:varyColors val="0"/>
        <c:ser>
          <c:idx val="0"/>
          <c:order val="0"/>
          <c:tx>
            <c:strRef>
              <c:f>'Fold change'!$P$1</c:f>
              <c:strCache>
                <c:ptCount val="1"/>
                <c:pt idx="0">
                  <c:v>S4_1</c:v>
                </c:pt>
              </c:strCache>
            </c:strRef>
          </c:tx>
          <c:spPr>
            <a:ln w="28575">
              <a:noFill/>
            </a:ln>
          </c:spPr>
          <c:xVal>
            <c:numRef>
              <c:f>'Fold change'!$P$2:$P$49</c:f>
              <c:numCache>
                <c:formatCode>General</c:formatCode>
                <c:ptCount val="48"/>
                <c:pt idx="0">
                  <c:v>0.434</c:v>
                </c:pt>
                <c:pt idx="1">
                  <c:v>2.1629999999999998</c:v>
                </c:pt>
                <c:pt idx="2">
                  <c:v>1.288</c:v>
                </c:pt>
                <c:pt idx="3">
                  <c:v>0.40400000000000003</c:v>
                </c:pt>
                <c:pt idx="4">
                  <c:v>0.96199999999999997</c:v>
                </c:pt>
                <c:pt idx="5">
                  <c:v>1.458</c:v>
                </c:pt>
                <c:pt idx="6">
                  <c:v>2.6459999999999999</c:v>
                </c:pt>
                <c:pt idx="7">
                  <c:v>3.4049999999999998</c:v>
                </c:pt>
                <c:pt idx="8">
                  <c:v>1.714</c:v>
                </c:pt>
                <c:pt idx="9">
                  <c:v>1.177</c:v>
                </c:pt>
                <c:pt idx="10">
                  <c:v>5.7140000000000004</c:v>
                </c:pt>
                <c:pt idx="11">
                  <c:v>1.0369999999999999</c:v>
                </c:pt>
                <c:pt idx="12">
                  <c:v>1.3240000000000001</c:v>
                </c:pt>
                <c:pt idx="13">
                  <c:v>1.224</c:v>
                </c:pt>
                <c:pt idx="14">
                  <c:v>4.9859999999999998</c:v>
                </c:pt>
                <c:pt idx="15">
                  <c:v>2.2850000000000001</c:v>
                </c:pt>
                <c:pt idx="16">
                  <c:v>0.69</c:v>
                </c:pt>
                <c:pt idx="17">
                  <c:v>0.81100000000000005</c:v>
                </c:pt>
                <c:pt idx="18">
                  <c:v>0.79</c:v>
                </c:pt>
                <c:pt idx="19">
                  <c:v>0.72499999999999998</c:v>
                </c:pt>
                <c:pt idx="20">
                  <c:v>1.363</c:v>
                </c:pt>
                <c:pt idx="21">
                  <c:v>2.9580000000000002</c:v>
                </c:pt>
                <c:pt idx="22">
                  <c:v>0.59799999999999998</c:v>
                </c:pt>
                <c:pt idx="23">
                  <c:v>1.8779999999999999</c:v>
                </c:pt>
                <c:pt idx="24">
                  <c:v>2.5870000000000002</c:v>
                </c:pt>
                <c:pt idx="25">
                  <c:v>4.2990000000000004</c:v>
                </c:pt>
                <c:pt idx="26">
                  <c:v>7.492</c:v>
                </c:pt>
                <c:pt idx="27">
                  <c:v>4.8630000000000004</c:v>
                </c:pt>
                <c:pt idx="28">
                  <c:v>3.48</c:v>
                </c:pt>
                <c:pt idx="29">
                  <c:v>5.4539999999999997</c:v>
                </c:pt>
                <c:pt idx="30">
                  <c:v>2.867</c:v>
                </c:pt>
                <c:pt idx="31">
                  <c:v>0.58499999999999996</c:v>
                </c:pt>
                <c:pt idx="32">
                  <c:v>5.2960000000000003</c:v>
                </c:pt>
                <c:pt idx="33">
                  <c:v>4.2510000000000003</c:v>
                </c:pt>
                <c:pt idx="34">
                  <c:v>3.552</c:v>
                </c:pt>
                <c:pt idx="35">
                  <c:v>4.524</c:v>
                </c:pt>
                <c:pt idx="36">
                  <c:v>10.956</c:v>
                </c:pt>
                <c:pt idx="37">
                  <c:v>7.3079999999999998</c:v>
                </c:pt>
                <c:pt idx="38">
                  <c:v>4.8239999999999998</c:v>
                </c:pt>
                <c:pt idx="39">
                  <c:v>1.75</c:v>
                </c:pt>
                <c:pt idx="40">
                  <c:v>0.48099999999999998</c:v>
                </c:pt>
                <c:pt idx="41">
                  <c:v>1.1080000000000001</c:v>
                </c:pt>
                <c:pt idx="42">
                  <c:v>7.2649999999999997</c:v>
                </c:pt>
                <c:pt idx="43">
                  <c:v>3.1909999999999998</c:v>
                </c:pt>
                <c:pt idx="44">
                  <c:v>1.8129999999999999</c:v>
                </c:pt>
                <c:pt idx="45">
                  <c:v>3.0859999999999999</c:v>
                </c:pt>
                <c:pt idx="46">
                  <c:v>1.1930000000000001</c:v>
                </c:pt>
                <c:pt idx="47">
                  <c:v>6.6040000000000001</c:v>
                </c:pt>
              </c:numCache>
            </c:numRef>
          </c:xVal>
          <c:yVal>
            <c:numRef>
              <c:f>'Fold change'!$Q$2:$Q$49</c:f>
              <c:numCache>
                <c:formatCode>General</c:formatCode>
                <c:ptCount val="48"/>
                <c:pt idx="0">
                  <c:v>4.3159999999999998</c:v>
                </c:pt>
                <c:pt idx="1">
                  <c:v>12.398999999999999</c:v>
                </c:pt>
                <c:pt idx="2">
                  <c:v>1.2390000000000001</c:v>
                </c:pt>
                <c:pt idx="3">
                  <c:v>1.8440000000000001</c:v>
                </c:pt>
                <c:pt idx="4">
                  <c:v>4.0629999999999997</c:v>
                </c:pt>
                <c:pt idx="5">
                  <c:v>3.9729999999999999</c:v>
                </c:pt>
                <c:pt idx="6">
                  <c:v>6.5179999999999998</c:v>
                </c:pt>
                <c:pt idx="7">
                  <c:v>2.3759999999999999</c:v>
                </c:pt>
                <c:pt idx="8">
                  <c:v>6.7290000000000001</c:v>
                </c:pt>
                <c:pt idx="9">
                  <c:v>3.2269999999999999</c:v>
                </c:pt>
                <c:pt idx="10">
                  <c:v>5.3150000000000004</c:v>
                </c:pt>
                <c:pt idx="11">
                  <c:v>0.92800000000000005</c:v>
                </c:pt>
                <c:pt idx="12">
                  <c:v>1.488</c:v>
                </c:pt>
                <c:pt idx="13">
                  <c:v>2.262</c:v>
                </c:pt>
                <c:pt idx="14">
                  <c:v>9.0060000000000002</c:v>
                </c:pt>
                <c:pt idx="15">
                  <c:v>5.0069999999999997</c:v>
                </c:pt>
                <c:pt idx="16">
                  <c:v>1.5680000000000001</c:v>
                </c:pt>
                <c:pt idx="17">
                  <c:v>1.2390000000000001</c:v>
                </c:pt>
                <c:pt idx="18">
                  <c:v>6.5860000000000003</c:v>
                </c:pt>
                <c:pt idx="19">
                  <c:v>8.952</c:v>
                </c:pt>
                <c:pt idx="20">
                  <c:v>1.77</c:v>
                </c:pt>
                <c:pt idx="21">
                  <c:v>3.0289999999999999</c:v>
                </c:pt>
                <c:pt idx="22">
                  <c:v>1.6160000000000001</c:v>
                </c:pt>
                <c:pt idx="23">
                  <c:v>8.1890000000000001</c:v>
                </c:pt>
                <c:pt idx="24">
                  <c:v>2.6739999999999999</c:v>
                </c:pt>
                <c:pt idx="25">
                  <c:v>4.194</c:v>
                </c:pt>
                <c:pt idx="26">
                  <c:v>7.8209999999999997</c:v>
                </c:pt>
                <c:pt idx="27">
                  <c:v>4.8520000000000003</c:v>
                </c:pt>
                <c:pt idx="28">
                  <c:v>19.452000000000002</c:v>
                </c:pt>
                <c:pt idx="29">
                  <c:v>7.2439999999999998</c:v>
                </c:pt>
                <c:pt idx="30">
                  <c:v>12.615</c:v>
                </c:pt>
                <c:pt idx="31">
                  <c:v>2.0270000000000001</c:v>
                </c:pt>
                <c:pt idx="32">
                  <c:v>5.0949999999999998</c:v>
                </c:pt>
                <c:pt idx="33">
                  <c:v>5.4039999999999999</c:v>
                </c:pt>
                <c:pt idx="34">
                  <c:v>5.96</c:v>
                </c:pt>
                <c:pt idx="35">
                  <c:v>11.763</c:v>
                </c:pt>
                <c:pt idx="36">
                  <c:v>17.95</c:v>
                </c:pt>
                <c:pt idx="37">
                  <c:v>34.36</c:v>
                </c:pt>
                <c:pt idx="38">
                  <c:v>8.0510000000000002</c:v>
                </c:pt>
                <c:pt idx="39">
                  <c:v>4.5309999999999997</c:v>
                </c:pt>
                <c:pt idx="40">
                  <c:v>0.85399999999999998</c:v>
                </c:pt>
                <c:pt idx="41">
                  <c:v>2.0670000000000002</c:v>
                </c:pt>
                <c:pt idx="42">
                  <c:v>6.0730000000000004</c:v>
                </c:pt>
                <c:pt idx="43">
                  <c:v>5.3840000000000003</c:v>
                </c:pt>
                <c:pt idx="44">
                  <c:v>4.4829999999999997</c:v>
                </c:pt>
                <c:pt idx="45">
                  <c:v>4.133</c:v>
                </c:pt>
                <c:pt idx="46">
                  <c:v>4.9950000000000001</c:v>
                </c:pt>
                <c:pt idx="47">
                  <c:v>7.798</c:v>
                </c:pt>
              </c:numCache>
            </c:numRef>
          </c:yVal>
          <c:smooth val="0"/>
          <c:extLst>
            <c:ext xmlns:c16="http://schemas.microsoft.com/office/drawing/2014/chart" uri="{C3380CC4-5D6E-409C-BE32-E72D297353CC}">
              <c16:uniqueId val="{00000000-7DFE-43A6-8F66-4D60EA55DC2B}"/>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7DFE-43A6-8F66-4D60EA55DC2B}"/>
            </c:ext>
          </c:extLst>
        </c:ser>
        <c:dLbls>
          <c:showLegendKey val="0"/>
          <c:showVal val="0"/>
          <c:showCatName val="0"/>
          <c:showSerName val="0"/>
          <c:showPercent val="0"/>
          <c:showBubbleSize val="0"/>
        </c:dLbls>
        <c:axId val="132225280"/>
        <c:axId val="132231552"/>
      </c:scatterChart>
      <c:valAx>
        <c:axId val="132225280"/>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231552"/>
        <c:crossesAt val="0.1"/>
        <c:crossBetween val="midCat"/>
      </c:valAx>
      <c:valAx>
        <c:axId val="132231552"/>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r>
                  <a:rPr lang="en-AU" sz="1100" baseline="0" dirty="0"/>
                  <a:t>)</a:t>
                </a:r>
                <a:endParaRPr lang="en-AU" sz="1100" dirty="0"/>
              </a:p>
            </c:rich>
          </c:tx>
          <c:overlay val="0"/>
        </c:title>
        <c:numFmt formatCode="General" sourceLinked="1"/>
        <c:majorTickMark val="out"/>
        <c:minorTickMark val="out"/>
        <c:tickLblPos val="nextTo"/>
        <c:crossAx val="132225280"/>
        <c:crossesAt val="0.1"/>
        <c:crossBetween val="midCat"/>
      </c:valAx>
    </c:plotArea>
    <c:plotVisOnly val="1"/>
    <c:dispBlanksAs val="gap"/>
    <c:showDLblsOverMax val="0"/>
  </c:chart>
  <c:spPr>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5</a:t>
            </a:r>
          </a:p>
        </c:rich>
      </c:tx>
      <c:overlay val="0"/>
    </c:title>
    <c:autoTitleDeleted val="0"/>
    <c:plotArea>
      <c:layout/>
      <c:scatterChart>
        <c:scatterStyle val="lineMarker"/>
        <c:varyColors val="0"/>
        <c:ser>
          <c:idx val="0"/>
          <c:order val="0"/>
          <c:tx>
            <c:strRef>
              <c:f>'Fold change'!$T$1</c:f>
              <c:strCache>
                <c:ptCount val="1"/>
                <c:pt idx="0">
                  <c:v>S5_1</c:v>
                </c:pt>
              </c:strCache>
            </c:strRef>
          </c:tx>
          <c:spPr>
            <a:ln w="28575">
              <a:noFill/>
            </a:ln>
          </c:spPr>
          <c:xVal>
            <c:numRef>
              <c:f>'Fold change'!$T$2:$T$49</c:f>
              <c:numCache>
                <c:formatCode>General</c:formatCode>
                <c:ptCount val="48"/>
                <c:pt idx="0">
                  <c:v>4.6210000000000004</c:v>
                </c:pt>
                <c:pt idx="1">
                  <c:v>6.782</c:v>
                </c:pt>
                <c:pt idx="2">
                  <c:v>3.464</c:v>
                </c:pt>
                <c:pt idx="3">
                  <c:v>2.3650000000000002</c:v>
                </c:pt>
                <c:pt idx="4">
                  <c:v>3.1480000000000001</c:v>
                </c:pt>
                <c:pt idx="5">
                  <c:v>3.3359999999999999</c:v>
                </c:pt>
                <c:pt idx="6">
                  <c:v>3.3</c:v>
                </c:pt>
                <c:pt idx="7">
                  <c:v>3.8730000000000002</c:v>
                </c:pt>
                <c:pt idx="8">
                  <c:v>3.8170000000000002</c:v>
                </c:pt>
                <c:pt idx="9">
                  <c:v>1.6419999999999999</c:v>
                </c:pt>
                <c:pt idx="10">
                  <c:v>11.432</c:v>
                </c:pt>
                <c:pt idx="11">
                  <c:v>1.379</c:v>
                </c:pt>
                <c:pt idx="12">
                  <c:v>3.903</c:v>
                </c:pt>
                <c:pt idx="13">
                  <c:v>2.234</c:v>
                </c:pt>
                <c:pt idx="14">
                  <c:v>8.3689999999999998</c:v>
                </c:pt>
                <c:pt idx="15">
                  <c:v>5.6740000000000004</c:v>
                </c:pt>
                <c:pt idx="16">
                  <c:v>1.2569999999999999</c:v>
                </c:pt>
                <c:pt idx="17">
                  <c:v>3.1779999999999999</c:v>
                </c:pt>
                <c:pt idx="18">
                  <c:v>3.66</c:v>
                </c:pt>
                <c:pt idx="19">
                  <c:v>3.1520000000000001</c:v>
                </c:pt>
                <c:pt idx="20">
                  <c:v>3.0569999999999999</c:v>
                </c:pt>
                <c:pt idx="21">
                  <c:v>5.5890000000000004</c:v>
                </c:pt>
                <c:pt idx="22">
                  <c:v>2.2770000000000001</c:v>
                </c:pt>
                <c:pt idx="23">
                  <c:v>4.077</c:v>
                </c:pt>
                <c:pt idx="24">
                  <c:v>5.4560000000000004</c:v>
                </c:pt>
                <c:pt idx="25">
                  <c:v>3.472</c:v>
                </c:pt>
                <c:pt idx="26">
                  <c:v>4.0179999999999998</c:v>
                </c:pt>
                <c:pt idx="27">
                  <c:v>6.0640000000000001</c:v>
                </c:pt>
                <c:pt idx="28">
                  <c:v>8.2409999999999997</c:v>
                </c:pt>
                <c:pt idx="29">
                  <c:v>9.1430000000000007</c:v>
                </c:pt>
                <c:pt idx="30">
                  <c:v>6.2409999999999997</c:v>
                </c:pt>
                <c:pt idx="31">
                  <c:v>1.653</c:v>
                </c:pt>
                <c:pt idx="32">
                  <c:v>5.4749999999999996</c:v>
                </c:pt>
                <c:pt idx="33">
                  <c:v>5.5149999999999997</c:v>
                </c:pt>
                <c:pt idx="34">
                  <c:v>8.5380000000000003</c:v>
                </c:pt>
                <c:pt idx="35">
                  <c:v>8.5969999999999995</c:v>
                </c:pt>
                <c:pt idx="36">
                  <c:v>17.669</c:v>
                </c:pt>
                <c:pt idx="37">
                  <c:v>15.577</c:v>
                </c:pt>
                <c:pt idx="38">
                  <c:v>6.1210000000000004</c:v>
                </c:pt>
                <c:pt idx="39">
                  <c:v>2.8580000000000001</c:v>
                </c:pt>
                <c:pt idx="40">
                  <c:v>1.27</c:v>
                </c:pt>
                <c:pt idx="41">
                  <c:v>3.6680000000000001</c:v>
                </c:pt>
                <c:pt idx="42">
                  <c:v>11.802</c:v>
                </c:pt>
                <c:pt idx="43">
                  <c:v>6.0970000000000004</c:v>
                </c:pt>
                <c:pt idx="44">
                  <c:v>4.8220000000000001</c:v>
                </c:pt>
                <c:pt idx="45">
                  <c:v>6.2969999999999997</c:v>
                </c:pt>
                <c:pt idx="46">
                  <c:v>1.353</c:v>
                </c:pt>
                <c:pt idx="47">
                  <c:v>11.11</c:v>
                </c:pt>
              </c:numCache>
            </c:numRef>
          </c:xVal>
          <c:yVal>
            <c:numRef>
              <c:f>'Fold change'!$U$2:$U$49</c:f>
              <c:numCache>
                <c:formatCode>General</c:formatCode>
                <c:ptCount val="48"/>
                <c:pt idx="0">
                  <c:v>11.881</c:v>
                </c:pt>
                <c:pt idx="1">
                  <c:v>19.417000000000002</c:v>
                </c:pt>
                <c:pt idx="2">
                  <c:v>3.294</c:v>
                </c:pt>
                <c:pt idx="3">
                  <c:v>6.4390000000000001</c:v>
                </c:pt>
                <c:pt idx="4">
                  <c:v>8.5990000000000002</c:v>
                </c:pt>
                <c:pt idx="5">
                  <c:v>3.9860000000000002</c:v>
                </c:pt>
                <c:pt idx="6">
                  <c:v>4.7480000000000002</c:v>
                </c:pt>
                <c:pt idx="7">
                  <c:v>6.1749999999999998</c:v>
                </c:pt>
                <c:pt idx="8">
                  <c:v>4.0030000000000001</c:v>
                </c:pt>
                <c:pt idx="9">
                  <c:v>1.641</c:v>
                </c:pt>
                <c:pt idx="10">
                  <c:v>17.245999999999999</c:v>
                </c:pt>
                <c:pt idx="11">
                  <c:v>2.2669999999999999</c:v>
                </c:pt>
                <c:pt idx="12">
                  <c:v>7.6079999999999997</c:v>
                </c:pt>
                <c:pt idx="13">
                  <c:v>2.95</c:v>
                </c:pt>
                <c:pt idx="14">
                  <c:v>10.315</c:v>
                </c:pt>
                <c:pt idx="15">
                  <c:v>5.6390000000000002</c:v>
                </c:pt>
                <c:pt idx="16">
                  <c:v>4.0579999999999998</c:v>
                </c:pt>
                <c:pt idx="17">
                  <c:v>7.5410000000000004</c:v>
                </c:pt>
                <c:pt idx="18">
                  <c:v>6.4379999999999997</c:v>
                </c:pt>
                <c:pt idx="19">
                  <c:v>5.1029999999999998</c:v>
                </c:pt>
                <c:pt idx="20">
                  <c:v>3.9329999999999998</c:v>
                </c:pt>
                <c:pt idx="21">
                  <c:v>36.561</c:v>
                </c:pt>
                <c:pt idx="22">
                  <c:v>2.6320000000000001</c:v>
                </c:pt>
                <c:pt idx="23">
                  <c:v>5.907</c:v>
                </c:pt>
                <c:pt idx="24">
                  <c:v>6.6130000000000004</c:v>
                </c:pt>
                <c:pt idx="25">
                  <c:v>12.102</c:v>
                </c:pt>
                <c:pt idx="26">
                  <c:v>13.834</c:v>
                </c:pt>
                <c:pt idx="27">
                  <c:v>6.7080000000000002</c:v>
                </c:pt>
                <c:pt idx="28">
                  <c:v>24.004999999999999</c:v>
                </c:pt>
                <c:pt idx="29">
                  <c:v>10.585000000000001</c:v>
                </c:pt>
                <c:pt idx="30">
                  <c:v>16.850000000000001</c:v>
                </c:pt>
                <c:pt idx="31">
                  <c:v>1.456</c:v>
                </c:pt>
                <c:pt idx="32">
                  <c:v>6.7380000000000004</c:v>
                </c:pt>
                <c:pt idx="33">
                  <c:v>8.3260000000000005</c:v>
                </c:pt>
                <c:pt idx="34">
                  <c:v>12.628</c:v>
                </c:pt>
                <c:pt idx="35">
                  <c:v>8.2509999999999994</c:v>
                </c:pt>
                <c:pt idx="36">
                  <c:v>17.75</c:v>
                </c:pt>
                <c:pt idx="37">
                  <c:v>40.090000000000003</c:v>
                </c:pt>
                <c:pt idx="38">
                  <c:v>5.5679999999999996</c:v>
                </c:pt>
                <c:pt idx="39">
                  <c:v>4.9729999999999999</c:v>
                </c:pt>
                <c:pt idx="40">
                  <c:v>2.9430000000000001</c:v>
                </c:pt>
                <c:pt idx="41">
                  <c:v>4.1440000000000001</c:v>
                </c:pt>
                <c:pt idx="42">
                  <c:v>10.9</c:v>
                </c:pt>
                <c:pt idx="43">
                  <c:v>5.5910000000000002</c:v>
                </c:pt>
                <c:pt idx="44">
                  <c:v>8.7200000000000006</c:v>
                </c:pt>
                <c:pt idx="45">
                  <c:v>13.679</c:v>
                </c:pt>
                <c:pt idx="46">
                  <c:v>4.5510000000000002</c:v>
                </c:pt>
                <c:pt idx="47">
                  <c:v>13.147</c:v>
                </c:pt>
              </c:numCache>
            </c:numRef>
          </c:yVal>
          <c:smooth val="0"/>
          <c:extLst>
            <c:ext xmlns:c16="http://schemas.microsoft.com/office/drawing/2014/chart" uri="{C3380CC4-5D6E-409C-BE32-E72D297353CC}">
              <c16:uniqueId val="{00000000-EA2A-4C6C-AD4E-9D5462757EBD}"/>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EA2A-4C6C-AD4E-9D5462757EBD}"/>
            </c:ext>
          </c:extLst>
        </c:ser>
        <c:dLbls>
          <c:showLegendKey val="0"/>
          <c:showVal val="0"/>
          <c:showCatName val="0"/>
          <c:showSerName val="0"/>
          <c:showPercent val="0"/>
          <c:showBubbleSize val="0"/>
        </c:dLbls>
        <c:axId val="132242048"/>
        <c:axId val="132244224"/>
      </c:scatterChart>
      <c:valAx>
        <c:axId val="132242048"/>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244224"/>
        <c:crossesAt val="0.1"/>
        <c:crossBetween val="midCat"/>
      </c:valAx>
      <c:valAx>
        <c:axId val="132244224"/>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2242048"/>
        <c:crossesAt val="0.1"/>
        <c:crossBetween val="midCat"/>
      </c:valAx>
    </c:plotArea>
    <c:plotVisOnly val="1"/>
    <c:dispBlanksAs val="gap"/>
    <c:showDLblsOverMax val="0"/>
  </c:chart>
  <c:spPr>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6A</a:t>
            </a:r>
          </a:p>
        </c:rich>
      </c:tx>
      <c:overlay val="0"/>
    </c:title>
    <c:autoTitleDeleted val="0"/>
    <c:plotArea>
      <c:layout/>
      <c:scatterChart>
        <c:scatterStyle val="lineMarker"/>
        <c:varyColors val="0"/>
        <c:ser>
          <c:idx val="0"/>
          <c:order val="0"/>
          <c:tx>
            <c:strRef>
              <c:f>'Fold change'!$X$1</c:f>
              <c:strCache>
                <c:ptCount val="1"/>
                <c:pt idx="0">
                  <c:v>S6A_1</c:v>
                </c:pt>
              </c:strCache>
            </c:strRef>
          </c:tx>
          <c:spPr>
            <a:ln w="28575">
              <a:noFill/>
            </a:ln>
          </c:spPr>
          <c:xVal>
            <c:numRef>
              <c:f>'Fold change'!$X$2:$X$49</c:f>
              <c:numCache>
                <c:formatCode>General</c:formatCode>
                <c:ptCount val="48"/>
                <c:pt idx="0">
                  <c:v>3.0739999999999998</c:v>
                </c:pt>
                <c:pt idx="1">
                  <c:v>3.3820000000000001</c:v>
                </c:pt>
                <c:pt idx="2">
                  <c:v>1.875</c:v>
                </c:pt>
                <c:pt idx="3">
                  <c:v>1.5449999999999999</c:v>
                </c:pt>
                <c:pt idx="4">
                  <c:v>5.9690000000000003</c:v>
                </c:pt>
                <c:pt idx="5">
                  <c:v>2.2170000000000001</c:v>
                </c:pt>
                <c:pt idx="6">
                  <c:v>4.9340000000000002</c:v>
                </c:pt>
                <c:pt idx="7">
                  <c:v>6.98</c:v>
                </c:pt>
                <c:pt idx="8">
                  <c:v>1.9430000000000001</c:v>
                </c:pt>
                <c:pt idx="9">
                  <c:v>3.698</c:v>
                </c:pt>
                <c:pt idx="10">
                  <c:v>9.1349999999999998</c:v>
                </c:pt>
                <c:pt idx="11">
                  <c:v>1.2929999999999999</c:v>
                </c:pt>
                <c:pt idx="12">
                  <c:v>2.6040000000000001</c:v>
                </c:pt>
                <c:pt idx="13">
                  <c:v>1.492</c:v>
                </c:pt>
                <c:pt idx="14">
                  <c:v>5.0449999999999999</c:v>
                </c:pt>
                <c:pt idx="15">
                  <c:v>4.2140000000000004</c:v>
                </c:pt>
                <c:pt idx="16">
                  <c:v>0.77300000000000002</c:v>
                </c:pt>
                <c:pt idx="17">
                  <c:v>1.8979999999999999</c:v>
                </c:pt>
                <c:pt idx="18">
                  <c:v>0.65800000000000003</c:v>
                </c:pt>
                <c:pt idx="19">
                  <c:v>0.86599999999999999</c:v>
                </c:pt>
                <c:pt idx="20">
                  <c:v>2.0409999999999999</c:v>
                </c:pt>
                <c:pt idx="21">
                  <c:v>2.76</c:v>
                </c:pt>
                <c:pt idx="22">
                  <c:v>2.2549999999999999</c:v>
                </c:pt>
                <c:pt idx="23">
                  <c:v>3.4060000000000001</c:v>
                </c:pt>
                <c:pt idx="24">
                  <c:v>4.47</c:v>
                </c:pt>
                <c:pt idx="25">
                  <c:v>3.754</c:v>
                </c:pt>
                <c:pt idx="26">
                  <c:v>10.275</c:v>
                </c:pt>
                <c:pt idx="27">
                  <c:v>7.0880000000000001</c:v>
                </c:pt>
                <c:pt idx="28">
                  <c:v>7.0629999999999997</c:v>
                </c:pt>
                <c:pt idx="29">
                  <c:v>6.5419999999999998</c:v>
                </c:pt>
                <c:pt idx="30">
                  <c:v>8.6780000000000008</c:v>
                </c:pt>
                <c:pt idx="31">
                  <c:v>3.1739999999999999</c:v>
                </c:pt>
                <c:pt idx="32">
                  <c:v>6.8680000000000003</c:v>
                </c:pt>
                <c:pt idx="33">
                  <c:v>5.7270000000000003</c:v>
                </c:pt>
                <c:pt idx="34">
                  <c:v>5.1779999999999999</c:v>
                </c:pt>
                <c:pt idx="35">
                  <c:v>6.8929999999999998</c:v>
                </c:pt>
                <c:pt idx="36">
                  <c:v>17.047000000000001</c:v>
                </c:pt>
                <c:pt idx="37">
                  <c:v>11.627000000000001</c:v>
                </c:pt>
                <c:pt idx="38">
                  <c:v>12.518000000000001</c:v>
                </c:pt>
                <c:pt idx="39">
                  <c:v>1.899</c:v>
                </c:pt>
                <c:pt idx="40">
                  <c:v>0.71399999999999997</c:v>
                </c:pt>
                <c:pt idx="41">
                  <c:v>1.2310000000000001</c:v>
                </c:pt>
                <c:pt idx="42">
                  <c:v>8.6880000000000006</c:v>
                </c:pt>
                <c:pt idx="43">
                  <c:v>4.3090000000000002</c:v>
                </c:pt>
                <c:pt idx="44">
                  <c:v>2.3969999999999998</c:v>
                </c:pt>
                <c:pt idx="45">
                  <c:v>4.548</c:v>
                </c:pt>
                <c:pt idx="46">
                  <c:v>1.274</c:v>
                </c:pt>
                <c:pt idx="47">
                  <c:v>7.1879999999999997</c:v>
                </c:pt>
              </c:numCache>
            </c:numRef>
          </c:xVal>
          <c:yVal>
            <c:numRef>
              <c:f>'Fold change'!$Y$2:$Y$49</c:f>
              <c:numCache>
                <c:formatCode>General</c:formatCode>
                <c:ptCount val="48"/>
                <c:pt idx="0">
                  <c:v>4.9989999999999997</c:v>
                </c:pt>
                <c:pt idx="1">
                  <c:v>7.2690000000000001</c:v>
                </c:pt>
                <c:pt idx="2">
                  <c:v>3.0259999999999998</c:v>
                </c:pt>
                <c:pt idx="3">
                  <c:v>3.9820000000000002</c:v>
                </c:pt>
                <c:pt idx="4">
                  <c:v>9.9890000000000008</c:v>
                </c:pt>
                <c:pt idx="5">
                  <c:v>2.125</c:v>
                </c:pt>
                <c:pt idx="6">
                  <c:v>10.404999999999999</c:v>
                </c:pt>
                <c:pt idx="7">
                  <c:v>29.859000000000002</c:v>
                </c:pt>
                <c:pt idx="8">
                  <c:v>4.6219999999999999</c:v>
                </c:pt>
                <c:pt idx="9">
                  <c:v>6.3730000000000002</c:v>
                </c:pt>
                <c:pt idx="10">
                  <c:v>9.5180000000000007</c:v>
                </c:pt>
                <c:pt idx="11">
                  <c:v>1.373</c:v>
                </c:pt>
                <c:pt idx="12">
                  <c:v>5.141</c:v>
                </c:pt>
                <c:pt idx="13">
                  <c:v>2.67</c:v>
                </c:pt>
                <c:pt idx="14">
                  <c:v>11.065</c:v>
                </c:pt>
                <c:pt idx="15">
                  <c:v>7.024</c:v>
                </c:pt>
                <c:pt idx="16">
                  <c:v>9.16</c:v>
                </c:pt>
                <c:pt idx="17">
                  <c:v>5.5460000000000003</c:v>
                </c:pt>
                <c:pt idx="18">
                  <c:v>0.94299999999999995</c:v>
                </c:pt>
                <c:pt idx="19">
                  <c:v>3.036</c:v>
                </c:pt>
                <c:pt idx="20">
                  <c:v>2.032</c:v>
                </c:pt>
                <c:pt idx="21">
                  <c:v>12.817</c:v>
                </c:pt>
                <c:pt idx="22">
                  <c:v>3.4649999999999999</c:v>
                </c:pt>
                <c:pt idx="23">
                  <c:v>3.8260000000000001</c:v>
                </c:pt>
                <c:pt idx="24">
                  <c:v>17.547000000000001</c:v>
                </c:pt>
                <c:pt idx="25">
                  <c:v>39.997999999999998</c:v>
                </c:pt>
                <c:pt idx="26">
                  <c:v>22.887</c:v>
                </c:pt>
                <c:pt idx="27">
                  <c:v>11.895</c:v>
                </c:pt>
                <c:pt idx="28">
                  <c:v>15.211</c:v>
                </c:pt>
                <c:pt idx="29">
                  <c:v>9.5009999999999994</c:v>
                </c:pt>
                <c:pt idx="30">
                  <c:v>12.965</c:v>
                </c:pt>
                <c:pt idx="31">
                  <c:v>2.919</c:v>
                </c:pt>
                <c:pt idx="32">
                  <c:v>6.5090000000000003</c:v>
                </c:pt>
                <c:pt idx="33">
                  <c:v>4.8650000000000002</c:v>
                </c:pt>
                <c:pt idx="34">
                  <c:v>10.173999999999999</c:v>
                </c:pt>
                <c:pt idx="35">
                  <c:v>54.173000000000002</c:v>
                </c:pt>
                <c:pt idx="36">
                  <c:v>22.952000000000002</c:v>
                </c:pt>
                <c:pt idx="37">
                  <c:v>70.400999999999996</c:v>
                </c:pt>
                <c:pt idx="38">
                  <c:v>99.575999999999993</c:v>
                </c:pt>
                <c:pt idx="39">
                  <c:v>1.9179999999999999</c:v>
                </c:pt>
                <c:pt idx="40">
                  <c:v>5.032</c:v>
                </c:pt>
                <c:pt idx="41">
                  <c:v>2.2429999999999999</c:v>
                </c:pt>
                <c:pt idx="42">
                  <c:v>5.2</c:v>
                </c:pt>
                <c:pt idx="43">
                  <c:v>2.988</c:v>
                </c:pt>
                <c:pt idx="44">
                  <c:v>8.09</c:v>
                </c:pt>
                <c:pt idx="45">
                  <c:v>8.9130000000000003</c:v>
                </c:pt>
                <c:pt idx="46">
                  <c:v>2.3490000000000002</c:v>
                </c:pt>
                <c:pt idx="47">
                  <c:v>9.3030000000000008</c:v>
                </c:pt>
              </c:numCache>
            </c:numRef>
          </c:yVal>
          <c:smooth val="0"/>
          <c:extLst>
            <c:ext xmlns:c16="http://schemas.microsoft.com/office/drawing/2014/chart" uri="{C3380CC4-5D6E-409C-BE32-E72D297353CC}">
              <c16:uniqueId val="{00000000-888D-4B6B-9BEB-8C2D5E526032}"/>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888D-4B6B-9BEB-8C2D5E526032}"/>
            </c:ext>
          </c:extLst>
        </c:ser>
        <c:dLbls>
          <c:showLegendKey val="0"/>
          <c:showVal val="0"/>
          <c:showCatName val="0"/>
          <c:showSerName val="0"/>
          <c:showPercent val="0"/>
          <c:showBubbleSize val="0"/>
        </c:dLbls>
        <c:axId val="132324352"/>
        <c:axId val="132330624"/>
      </c:scatterChart>
      <c:valAx>
        <c:axId val="132324352"/>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330624"/>
        <c:crossesAt val="0.1"/>
        <c:crossBetween val="midCat"/>
      </c:valAx>
      <c:valAx>
        <c:axId val="132330624"/>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2324352"/>
        <c:crossesAt val="0.1"/>
        <c:crossBetween val="midCat"/>
      </c:valAx>
    </c:plotArea>
    <c:plotVisOnly val="1"/>
    <c:dispBlanksAs val="gap"/>
    <c:showDLblsOverMax val="0"/>
  </c:chart>
  <c:spPr>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6B</a:t>
            </a:r>
          </a:p>
        </c:rich>
      </c:tx>
      <c:overlay val="0"/>
    </c:title>
    <c:autoTitleDeleted val="0"/>
    <c:plotArea>
      <c:layout>
        <c:manualLayout>
          <c:layoutTarget val="inner"/>
          <c:xMode val="edge"/>
          <c:yMode val="edge"/>
          <c:x val="0.18624755019079078"/>
          <c:y val="0.15907666533608739"/>
          <c:w val="0.73774555225451699"/>
          <c:h val="0.66129193601841885"/>
        </c:manualLayout>
      </c:layout>
      <c:scatterChart>
        <c:scatterStyle val="lineMarker"/>
        <c:varyColors val="0"/>
        <c:ser>
          <c:idx val="0"/>
          <c:order val="0"/>
          <c:tx>
            <c:strRef>
              <c:f>'Fold change'!$AB$1</c:f>
              <c:strCache>
                <c:ptCount val="1"/>
                <c:pt idx="0">
                  <c:v>S6B_1</c:v>
                </c:pt>
              </c:strCache>
            </c:strRef>
          </c:tx>
          <c:spPr>
            <a:ln w="28575">
              <a:noFill/>
            </a:ln>
          </c:spPr>
          <c:xVal>
            <c:numRef>
              <c:f>'Fold change'!$AB$2:$AB$49</c:f>
              <c:numCache>
                <c:formatCode>General</c:formatCode>
                <c:ptCount val="48"/>
                <c:pt idx="0">
                  <c:v>7.28</c:v>
                </c:pt>
                <c:pt idx="1">
                  <c:v>7.1239999999999997</c:v>
                </c:pt>
                <c:pt idx="2">
                  <c:v>6.0860000000000003</c:v>
                </c:pt>
                <c:pt idx="3">
                  <c:v>3.2040000000000002</c:v>
                </c:pt>
                <c:pt idx="4">
                  <c:v>6.84</c:v>
                </c:pt>
                <c:pt idx="5">
                  <c:v>4.3369999999999997</c:v>
                </c:pt>
                <c:pt idx="6">
                  <c:v>4.7779999999999996</c:v>
                </c:pt>
                <c:pt idx="7">
                  <c:v>7.0149999999999997</c:v>
                </c:pt>
                <c:pt idx="8">
                  <c:v>4.9409999999999998</c:v>
                </c:pt>
                <c:pt idx="9">
                  <c:v>7.5350000000000001</c:v>
                </c:pt>
                <c:pt idx="10">
                  <c:v>16.646000000000001</c:v>
                </c:pt>
                <c:pt idx="11">
                  <c:v>2.5510000000000002</c:v>
                </c:pt>
                <c:pt idx="12">
                  <c:v>3.5489999999999999</c:v>
                </c:pt>
                <c:pt idx="13">
                  <c:v>2.9510000000000001</c:v>
                </c:pt>
                <c:pt idx="14">
                  <c:v>9.43</c:v>
                </c:pt>
                <c:pt idx="15">
                  <c:v>10.294</c:v>
                </c:pt>
                <c:pt idx="16">
                  <c:v>1.5149999999999999</c:v>
                </c:pt>
                <c:pt idx="17">
                  <c:v>4.681</c:v>
                </c:pt>
                <c:pt idx="18">
                  <c:v>0.86899999999999999</c:v>
                </c:pt>
                <c:pt idx="19">
                  <c:v>1.359</c:v>
                </c:pt>
                <c:pt idx="20">
                  <c:v>3.1059999999999999</c:v>
                </c:pt>
                <c:pt idx="21">
                  <c:v>8.766</c:v>
                </c:pt>
                <c:pt idx="22">
                  <c:v>3.1160000000000001</c:v>
                </c:pt>
                <c:pt idx="23">
                  <c:v>4.5549999999999997</c:v>
                </c:pt>
                <c:pt idx="24">
                  <c:v>7.44</c:v>
                </c:pt>
                <c:pt idx="25">
                  <c:v>6.6310000000000002</c:v>
                </c:pt>
                <c:pt idx="26">
                  <c:v>16.61</c:v>
                </c:pt>
                <c:pt idx="27">
                  <c:v>9.8019999999999996</c:v>
                </c:pt>
                <c:pt idx="28">
                  <c:v>13.827</c:v>
                </c:pt>
                <c:pt idx="29">
                  <c:v>11.175000000000001</c:v>
                </c:pt>
                <c:pt idx="30">
                  <c:v>18.408000000000001</c:v>
                </c:pt>
                <c:pt idx="31">
                  <c:v>1.5820000000000001</c:v>
                </c:pt>
                <c:pt idx="32">
                  <c:v>8.1189999999999998</c:v>
                </c:pt>
                <c:pt idx="33">
                  <c:v>7.1079999999999997</c:v>
                </c:pt>
                <c:pt idx="34">
                  <c:v>11.081</c:v>
                </c:pt>
                <c:pt idx="35">
                  <c:v>13.599</c:v>
                </c:pt>
                <c:pt idx="36">
                  <c:v>23.641999999999999</c:v>
                </c:pt>
                <c:pt idx="37">
                  <c:v>18.579999999999998</c:v>
                </c:pt>
                <c:pt idx="38">
                  <c:v>15.965999999999999</c:v>
                </c:pt>
                <c:pt idx="39">
                  <c:v>14.69</c:v>
                </c:pt>
                <c:pt idx="40">
                  <c:v>1.46</c:v>
                </c:pt>
                <c:pt idx="41">
                  <c:v>7.0650000000000004</c:v>
                </c:pt>
                <c:pt idx="42">
                  <c:v>33.703000000000003</c:v>
                </c:pt>
                <c:pt idx="43">
                  <c:v>14.077</c:v>
                </c:pt>
                <c:pt idx="44">
                  <c:v>4.5590000000000002</c:v>
                </c:pt>
                <c:pt idx="45">
                  <c:v>7.9950000000000001</c:v>
                </c:pt>
                <c:pt idx="46">
                  <c:v>5.6479999999999997</c:v>
                </c:pt>
                <c:pt idx="47">
                  <c:v>11.37</c:v>
                </c:pt>
              </c:numCache>
            </c:numRef>
          </c:xVal>
          <c:yVal>
            <c:numRef>
              <c:f>'Fold change'!$AC$2:$AC$49</c:f>
              <c:numCache>
                <c:formatCode>General</c:formatCode>
                <c:ptCount val="48"/>
                <c:pt idx="0">
                  <c:v>13.24</c:v>
                </c:pt>
                <c:pt idx="1">
                  <c:v>28.47</c:v>
                </c:pt>
                <c:pt idx="2">
                  <c:v>15.2</c:v>
                </c:pt>
                <c:pt idx="3">
                  <c:v>7.133</c:v>
                </c:pt>
                <c:pt idx="4">
                  <c:v>20.998999999999999</c:v>
                </c:pt>
                <c:pt idx="5">
                  <c:v>7.5190000000000001</c:v>
                </c:pt>
                <c:pt idx="6">
                  <c:v>18.003</c:v>
                </c:pt>
                <c:pt idx="7">
                  <c:v>29.222999999999999</c:v>
                </c:pt>
                <c:pt idx="8">
                  <c:v>9.8390000000000004</c:v>
                </c:pt>
                <c:pt idx="9">
                  <c:v>25.210999999999999</c:v>
                </c:pt>
                <c:pt idx="10">
                  <c:v>47.96</c:v>
                </c:pt>
                <c:pt idx="11">
                  <c:v>2.222</c:v>
                </c:pt>
                <c:pt idx="12">
                  <c:v>6.9779999999999998</c:v>
                </c:pt>
                <c:pt idx="13">
                  <c:v>7.9850000000000003</c:v>
                </c:pt>
                <c:pt idx="14">
                  <c:v>23.166</c:v>
                </c:pt>
                <c:pt idx="15">
                  <c:v>11.339</c:v>
                </c:pt>
                <c:pt idx="16">
                  <c:v>15.009</c:v>
                </c:pt>
                <c:pt idx="17">
                  <c:v>8.15</c:v>
                </c:pt>
                <c:pt idx="18">
                  <c:v>2.74</c:v>
                </c:pt>
                <c:pt idx="19">
                  <c:v>2.492</c:v>
                </c:pt>
                <c:pt idx="20">
                  <c:v>3.6549999999999998</c:v>
                </c:pt>
                <c:pt idx="21">
                  <c:v>52.98</c:v>
                </c:pt>
                <c:pt idx="22">
                  <c:v>6.7640000000000002</c:v>
                </c:pt>
                <c:pt idx="23">
                  <c:v>11.41</c:v>
                </c:pt>
                <c:pt idx="24">
                  <c:v>22.856999999999999</c:v>
                </c:pt>
                <c:pt idx="25">
                  <c:v>59.728000000000002</c:v>
                </c:pt>
                <c:pt idx="26">
                  <c:v>46.540999999999997</c:v>
                </c:pt>
                <c:pt idx="27">
                  <c:v>14.863</c:v>
                </c:pt>
                <c:pt idx="28">
                  <c:v>50.412999999999997</c:v>
                </c:pt>
                <c:pt idx="29">
                  <c:v>15.439</c:v>
                </c:pt>
                <c:pt idx="30">
                  <c:v>22.962</c:v>
                </c:pt>
                <c:pt idx="31">
                  <c:v>5.7320000000000002</c:v>
                </c:pt>
                <c:pt idx="32">
                  <c:v>8.593</c:v>
                </c:pt>
                <c:pt idx="33">
                  <c:v>12.247</c:v>
                </c:pt>
                <c:pt idx="34">
                  <c:v>16.202999999999999</c:v>
                </c:pt>
                <c:pt idx="35">
                  <c:v>54.804000000000002</c:v>
                </c:pt>
                <c:pt idx="36">
                  <c:v>44.866</c:v>
                </c:pt>
                <c:pt idx="37">
                  <c:v>47.024000000000001</c:v>
                </c:pt>
                <c:pt idx="38">
                  <c:v>34.182000000000002</c:v>
                </c:pt>
                <c:pt idx="39">
                  <c:v>72.277000000000001</c:v>
                </c:pt>
                <c:pt idx="40">
                  <c:v>5.6849999999999996</c:v>
                </c:pt>
                <c:pt idx="41">
                  <c:v>11.79</c:v>
                </c:pt>
                <c:pt idx="42">
                  <c:v>31.959</c:v>
                </c:pt>
                <c:pt idx="43">
                  <c:v>37.896999999999998</c:v>
                </c:pt>
                <c:pt idx="44">
                  <c:v>13.435</c:v>
                </c:pt>
                <c:pt idx="45">
                  <c:v>24.462</c:v>
                </c:pt>
                <c:pt idx="46">
                  <c:v>19.771999999999998</c:v>
                </c:pt>
                <c:pt idx="47">
                  <c:v>38.130000000000003</c:v>
                </c:pt>
              </c:numCache>
            </c:numRef>
          </c:yVal>
          <c:smooth val="0"/>
          <c:extLst>
            <c:ext xmlns:c16="http://schemas.microsoft.com/office/drawing/2014/chart" uri="{C3380CC4-5D6E-409C-BE32-E72D297353CC}">
              <c16:uniqueId val="{00000000-F85F-49BF-9199-17AAE8B421B6}"/>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F85F-49BF-9199-17AAE8B421B6}"/>
            </c:ext>
          </c:extLst>
        </c:ser>
        <c:dLbls>
          <c:showLegendKey val="0"/>
          <c:showVal val="0"/>
          <c:showCatName val="0"/>
          <c:showSerName val="0"/>
          <c:showPercent val="0"/>
          <c:showBubbleSize val="0"/>
        </c:dLbls>
        <c:axId val="132345216"/>
        <c:axId val="132347392"/>
      </c:scatterChart>
      <c:valAx>
        <c:axId val="132345216"/>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347392"/>
        <c:crossesAt val="0.1"/>
        <c:crossBetween val="midCat"/>
      </c:valAx>
      <c:valAx>
        <c:axId val="132347392"/>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r>
                  <a:rPr lang="en-AU" sz="1100" baseline="0" dirty="0"/>
                  <a:t>)</a:t>
                </a:r>
                <a:endParaRPr lang="en-AU" sz="1100" dirty="0"/>
              </a:p>
            </c:rich>
          </c:tx>
          <c:overlay val="0"/>
        </c:title>
        <c:numFmt formatCode="General" sourceLinked="1"/>
        <c:majorTickMark val="out"/>
        <c:minorTickMark val="out"/>
        <c:tickLblPos val="nextTo"/>
        <c:crossAx val="132345216"/>
        <c:crossesAt val="0.1"/>
        <c:crossBetween val="midCat"/>
      </c:valAx>
    </c:plotArea>
    <c:plotVisOnly val="1"/>
    <c:dispBlanksAs val="gap"/>
    <c:showDLblsOverMax val="0"/>
  </c:chart>
  <c:spPr>
    <a:ln>
      <a:noFill/>
    </a:ln>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7F</a:t>
            </a:r>
          </a:p>
        </c:rich>
      </c:tx>
      <c:overlay val="0"/>
    </c:title>
    <c:autoTitleDeleted val="0"/>
    <c:plotArea>
      <c:layout/>
      <c:scatterChart>
        <c:scatterStyle val="lineMarker"/>
        <c:varyColors val="0"/>
        <c:ser>
          <c:idx val="0"/>
          <c:order val="0"/>
          <c:tx>
            <c:strRef>
              <c:f>'Fold change'!$AF$1</c:f>
              <c:strCache>
                <c:ptCount val="1"/>
                <c:pt idx="0">
                  <c:v>S7F_1</c:v>
                </c:pt>
              </c:strCache>
            </c:strRef>
          </c:tx>
          <c:spPr>
            <a:ln w="28575">
              <a:noFill/>
            </a:ln>
          </c:spPr>
          <c:xVal>
            <c:numRef>
              <c:f>'Fold change'!$AF$2:$AF$49</c:f>
              <c:numCache>
                <c:formatCode>General</c:formatCode>
                <c:ptCount val="48"/>
                <c:pt idx="0">
                  <c:v>5.0369999999999999</c:v>
                </c:pt>
                <c:pt idx="1">
                  <c:v>8.5760000000000005</c:v>
                </c:pt>
                <c:pt idx="2">
                  <c:v>4.069</c:v>
                </c:pt>
                <c:pt idx="3">
                  <c:v>3.2010000000000001</c:v>
                </c:pt>
                <c:pt idx="4">
                  <c:v>5.8760000000000003</c:v>
                </c:pt>
                <c:pt idx="5">
                  <c:v>5.41</c:v>
                </c:pt>
                <c:pt idx="6">
                  <c:v>4.7850000000000001</c:v>
                </c:pt>
                <c:pt idx="7">
                  <c:v>10.603999999999999</c:v>
                </c:pt>
                <c:pt idx="8">
                  <c:v>5.6619999999999999</c:v>
                </c:pt>
                <c:pt idx="9">
                  <c:v>7.0010000000000003</c:v>
                </c:pt>
                <c:pt idx="10">
                  <c:v>15.02</c:v>
                </c:pt>
                <c:pt idx="11">
                  <c:v>3.0619999999999998</c:v>
                </c:pt>
                <c:pt idx="12">
                  <c:v>2.89</c:v>
                </c:pt>
                <c:pt idx="13">
                  <c:v>2.6589999999999998</c:v>
                </c:pt>
                <c:pt idx="14">
                  <c:v>13.053000000000001</c:v>
                </c:pt>
                <c:pt idx="15">
                  <c:v>9.3740000000000006</c:v>
                </c:pt>
                <c:pt idx="16">
                  <c:v>1.0509999999999999</c:v>
                </c:pt>
                <c:pt idx="17">
                  <c:v>3.226</c:v>
                </c:pt>
                <c:pt idx="18">
                  <c:v>2.12</c:v>
                </c:pt>
                <c:pt idx="19">
                  <c:v>2.9140000000000001</c:v>
                </c:pt>
                <c:pt idx="20">
                  <c:v>4.4249999999999998</c:v>
                </c:pt>
                <c:pt idx="21">
                  <c:v>6.8609999999999998</c:v>
                </c:pt>
                <c:pt idx="22">
                  <c:v>2.5569999999999999</c:v>
                </c:pt>
                <c:pt idx="23">
                  <c:v>6.2149999999999999</c:v>
                </c:pt>
                <c:pt idx="24">
                  <c:v>4.3719999999999999</c:v>
                </c:pt>
                <c:pt idx="25">
                  <c:v>3.43</c:v>
                </c:pt>
                <c:pt idx="26">
                  <c:v>11.632999999999999</c:v>
                </c:pt>
                <c:pt idx="27">
                  <c:v>7.2329999999999997</c:v>
                </c:pt>
                <c:pt idx="28">
                  <c:v>7.423</c:v>
                </c:pt>
                <c:pt idx="29">
                  <c:v>7.2759999999999998</c:v>
                </c:pt>
                <c:pt idx="30">
                  <c:v>8.1790000000000003</c:v>
                </c:pt>
                <c:pt idx="31">
                  <c:v>1.111</c:v>
                </c:pt>
                <c:pt idx="32">
                  <c:v>4.2720000000000002</c:v>
                </c:pt>
                <c:pt idx="33">
                  <c:v>6.2229999999999999</c:v>
                </c:pt>
                <c:pt idx="34">
                  <c:v>8.5440000000000005</c:v>
                </c:pt>
                <c:pt idx="35">
                  <c:v>6.07</c:v>
                </c:pt>
                <c:pt idx="36">
                  <c:v>17.309000000000001</c:v>
                </c:pt>
                <c:pt idx="37">
                  <c:v>17.478999999999999</c:v>
                </c:pt>
                <c:pt idx="38">
                  <c:v>7.8890000000000002</c:v>
                </c:pt>
                <c:pt idx="39">
                  <c:v>3.03</c:v>
                </c:pt>
                <c:pt idx="40">
                  <c:v>1.2210000000000001</c:v>
                </c:pt>
                <c:pt idx="41">
                  <c:v>2.2949999999999999</c:v>
                </c:pt>
                <c:pt idx="42">
                  <c:v>9.8170000000000002</c:v>
                </c:pt>
                <c:pt idx="43">
                  <c:v>5.99</c:v>
                </c:pt>
                <c:pt idx="44">
                  <c:v>4.66</c:v>
                </c:pt>
                <c:pt idx="45">
                  <c:v>4.2530000000000001</c:v>
                </c:pt>
                <c:pt idx="46">
                  <c:v>3.1139999999999999</c:v>
                </c:pt>
                <c:pt idx="47">
                  <c:v>7.8550000000000004</c:v>
                </c:pt>
              </c:numCache>
            </c:numRef>
          </c:xVal>
          <c:yVal>
            <c:numRef>
              <c:f>'Fold change'!$AG$2:$AG$49</c:f>
              <c:numCache>
                <c:formatCode>General</c:formatCode>
                <c:ptCount val="48"/>
                <c:pt idx="0">
                  <c:v>11.053000000000001</c:v>
                </c:pt>
                <c:pt idx="1">
                  <c:v>12.071999999999999</c:v>
                </c:pt>
                <c:pt idx="2">
                  <c:v>2.8769999999999998</c:v>
                </c:pt>
                <c:pt idx="3">
                  <c:v>3.944</c:v>
                </c:pt>
                <c:pt idx="4">
                  <c:v>9.4260000000000002</c:v>
                </c:pt>
                <c:pt idx="5">
                  <c:v>9.2620000000000005</c:v>
                </c:pt>
                <c:pt idx="6">
                  <c:v>5.742</c:v>
                </c:pt>
                <c:pt idx="7">
                  <c:v>12.625999999999999</c:v>
                </c:pt>
                <c:pt idx="8">
                  <c:v>6.7119999999999997</c:v>
                </c:pt>
                <c:pt idx="9">
                  <c:v>11.29</c:v>
                </c:pt>
                <c:pt idx="10">
                  <c:v>16.234000000000002</c:v>
                </c:pt>
                <c:pt idx="11">
                  <c:v>3.2690000000000001</c:v>
                </c:pt>
                <c:pt idx="12">
                  <c:v>5.9109999999999996</c:v>
                </c:pt>
                <c:pt idx="13">
                  <c:v>3.206</c:v>
                </c:pt>
                <c:pt idx="14">
                  <c:v>12.840999999999999</c:v>
                </c:pt>
                <c:pt idx="15">
                  <c:v>9.8360000000000003</c:v>
                </c:pt>
                <c:pt idx="16">
                  <c:v>2.5369999999999999</c:v>
                </c:pt>
                <c:pt idx="17">
                  <c:v>5.4169999999999998</c:v>
                </c:pt>
                <c:pt idx="18">
                  <c:v>5.5739999999999998</c:v>
                </c:pt>
                <c:pt idx="19">
                  <c:v>4.3079999999999998</c:v>
                </c:pt>
                <c:pt idx="20">
                  <c:v>4.8319999999999999</c:v>
                </c:pt>
                <c:pt idx="21">
                  <c:v>7.6630000000000003</c:v>
                </c:pt>
                <c:pt idx="22">
                  <c:v>2.4089999999999998</c:v>
                </c:pt>
                <c:pt idx="23">
                  <c:v>7.6470000000000002</c:v>
                </c:pt>
                <c:pt idx="24">
                  <c:v>3.8010000000000002</c:v>
                </c:pt>
                <c:pt idx="25">
                  <c:v>5.617</c:v>
                </c:pt>
                <c:pt idx="26">
                  <c:v>14.584</c:v>
                </c:pt>
                <c:pt idx="27">
                  <c:v>8.1479999999999997</c:v>
                </c:pt>
                <c:pt idx="28">
                  <c:v>18.579999999999998</c:v>
                </c:pt>
                <c:pt idx="29">
                  <c:v>8.5790000000000006</c:v>
                </c:pt>
                <c:pt idx="30">
                  <c:v>17.736000000000001</c:v>
                </c:pt>
                <c:pt idx="31">
                  <c:v>1.32</c:v>
                </c:pt>
                <c:pt idx="32">
                  <c:v>4.0880000000000001</c:v>
                </c:pt>
                <c:pt idx="33">
                  <c:v>6.1760000000000002</c:v>
                </c:pt>
                <c:pt idx="34">
                  <c:v>12.672000000000001</c:v>
                </c:pt>
                <c:pt idx="35">
                  <c:v>8.3539999999999992</c:v>
                </c:pt>
                <c:pt idx="36">
                  <c:v>17.369</c:v>
                </c:pt>
                <c:pt idx="37">
                  <c:v>15.739000000000001</c:v>
                </c:pt>
                <c:pt idx="38">
                  <c:v>9.5440000000000005</c:v>
                </c:pt>
                <c:pt idx="39">
                  <c:v>3.202</c:v>
                </c:pt>
                <c:pt idx="40">
                  <c:v>1.2789999999999999</c:v>
                </c:pt>
                <c:pt idx="41">
                  <c:v>3.3980000000000001</c:v>
                </c:pt>
                <c:pt idx="42">
                  <c:v>8.4920000000000009</c:v>
                </c:pt>
                <c:pt idx="43">
                  <c:v>5.0970000000000004</c:v>
                </c:pt>
                <c:pt idx="44">
                  <c:v>4.6829999999999998</c:v>
                </c:pt>
                <c:pt idx="45">
                  <c:v>3.4630000000000001</c:v>
                </c:pt>
                <c:pt idx="46">
                  <c:v>6.6079999999999997</c:v>
                </c:pt>
                <c:pt idx="47">
                  <c:v>10.968999999999999</c:v>
                </c:pt>
              </c:numCache>
            </c:numRef>
          </c:yVal>
          <c:smooth val="0"/>
          <c:extLst>
            <c:ext xmlns:c16="http://schemas.microsoft.com/office/drawing/2014/chart" uri="{C3380CC4-5D6E-409C-BE32-E72D297353CC}">
              <c16:uniqueId val="{00000000-2AF3-448F-81AB-CCF900208923}"/>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2AF3-448F-81AB-CCF900208923}"/>
            </c:ext>
          </c:extLst>
        </c:ser>
        <c:dLbls>
          <c:showLegendKey val="0"/>
          <c:showVal val="0"/>
          <c:showCatName val="0"/>
          <c:showSerName val="0"/>
          <c:showPercent val="0"/>
          <c:showBubbleSize val="0"/>
        </c:dLbls>
        <c:axId val="132370816"/>
        <c:axId val="132372736"/>
      </c:scatterChart>
      <c:valAx>
        <c:axId val="132370816"/>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372736"/>
        <c:crossesAt val="0.1"/>
        <c:crossBetween val="midCat"/>
      </c:valAx>
      <c:valAx>
        <c:axId val="132372736"/>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2370816"/>
        <c:crossesAt val="0.1"/>
        <c:crossBetween val="midCat"/>
      </c:valAx>
    </c:plotArea>
    <c:plotVisOnly val="1"/>
    <c:dispBlanksAs val="gap"/>
    <c:showDLblsOverMax val="0"/>
  </c:chart>
  <c:spPr>
    <a:ln>
      <a:noFill/>
    </a:ln>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9V</a:t>
            </a:r>
          </a:p>
        </c:rich>
      </c:tx>
      <c:overlay val="0"/>
    </c:title>
    <c:autoTitleDeleted val="0"/>
    <c:plotArea>
      <c:layout/>
      <c:scatterChart>
        <c:scatterStyle val="lineMarker"/>
        <c:varyColors val="0"/>
        <c:ser>
          <c:idx val="0"/>
          <c:order val="0"/>
          <c:tx>
            <c:strRef>
              <c:f>'Fold change'!$AJ$1</c:f>
              <c:strCache>
                <c:ptCount val="1"/>
                <c:pt idx="0">
                  <c:v>S9V_1</c:v>
                </c:pt>
              </c:strCache>
            </c:strRef>
          </c:tx>
          <c:spPr>
            <a:ln w="28575">
              <a:noFill/>
            </a:ln>
          </c:spPr>
          <c:xVal>
            <c:numRef>
              <c:f>'Fold change'!$AJ$2:$AJ$49</c:f>
              <c:numCache>
                <c:formatCode>General</c:formatCode>
                <c:ptCount val="48"/>
                <c:pt idx="0">
                  <c:v>3.3929999999999998</c:v>
                </c:pt>
                <c:pt idx="1">
                  <c:v>6.5259999999999998</c:v>
                </c:pt>
                <c:pt idx="2">
                  <c:v>2.024</c:v>
                </c:pt>
                <c:pt idx="3">
                  <c:v>2.2280000000000002</c:v>
                </c:pt>
                <c:pt idx="4">
                  <c:v>3.403</c:v>
                </c:pt>
                <c:pt idx="5">
                  <c:v>3.2730000000000001</c:v>
                </c:pt>
                <c:pt idx="6">
                  <c:v>3.86</c:v>
                </c:pt>
                <c:pt idx="7">
                  <c:v>4.1929999999999996</c:v>
                </c:pt>
                <c:pt idx="8">
                  <c:v>4.74</c:v>
                </c:pt>
                <c:pt idx="9">
                  <c:v>4.67</c:v>
                </c:pt>
                <c:pt idx="10">
                  <c:v>8.8580000000000005</c:v>
                </c:pt>
                <c:pt idx="11">
                  <c:v>1.671</c:v>
                </c:pt>
                <c:pt idx="12">
                  <c:v>7.7709999999999999</c:v>
                </c:pt>
                <c:pt idx="13">
                  <c:v>1.714</c:v>
                </c:pt>
                <c:pt idx="14">
                  <c:v>3.681</c:v>
                </c:pt>
                <c:pt idx="15">
                  <c:v>5.4539999999999997</c:v>
                </c:pt>
                <c:pt idx="16">
                  <c:v>1.458</c:v>
                </c:pt>
                <c:pt idx="17">
                  <c:v>1.45</c:v>
                </c:pt>
                <c:pt idx="18">
                  <c:v>0.63400000000000001</c:v>
                </c:pt>
                <c:pt idx="19">
                  <c:v>0.68100000000000005</c:v>
                </c:pt>
                <c:pt idx="20">
                  <c:v>2.883</c:v>
                </c:pt>
                <c:pt idx="21">
                  <c:v>5.6909999999999998</c:v>
                </c:pt>
                <c:pt idx="22">
                  <c:v>1.984</c:v>
                </c:pt>
                <c:pt idx="23">
                  <c:v>3.2709999999999999</c:v>
                </c:pt>
                <c:pt idx="24">
                  <c:v>3.855</c:v>
                </c:pt>
                <c:pt idx="25">
                  <c:v>5.7880000000000003</c:v>
                </c:pt>
                <c:pt idx="26">
                  <c:v>3.4079999999999999</c:v>
                </c:pt>
                <c:pt idx="27">
                  <c:v>7.798</c:v>
                </c:pt>
                <c:pt idx="28">
                  <c:v>14.121</c:v>
                </c:pt>
                <c:pt idx="29">
                  <c:v>8.8859999999999992</c:v>
                </c:pt>
                <c:pt idx="30">
                  <c:v>11.946999999999999</c:v>
                </c:pt>
                <c:pt idx="31">
                  <c:v>1.5680000000000001</c:v>
                </c:pt>
                <c:pt idx="32">
                  <c:v>7.8070000000000004</c:v>
                </c:pt>
                <c:pt idx="33">
                  <c:v>5.9560000000000004</c:v>
                </c:pt>
                <c:pt idx="34">
                  <c:v>9.9570000000000007</c:v>
                </c:pt>
                <c:pt idx="35">
                  <c:v>7.0069999999999997</c:v>
                </c:pt>
                <c:pt idx="36">
                  <c:v>13.193</c:v>
                </c:pt>
                <c:pt idx="37">
                  <c:v>12.526999999999999</c:v>
                </c:pt>
                <c:pt idx="38">
                  <c:v>6.59</c:v>
                </c:pt>
                <c:pt idx="39">
                  <c:v>4.1390000000000002</c:v>
                </c:pt>
                <c:pt idx="40">
                  <c:v>1.726</c:v>
                </c:pt>
                <c:pt idx="41">
                  <c:v>1.7450000000000001</c:v>
                </c:pt>
                <c:pt idx="42">
                  <c:v>6.601</c:v>
                </c:pt>
                <c:pt idx="43">
                  <c:v>7.2119999999999997</c:v>
                </c:pt>
                <c:pt idx="44">
                  <c:v>3.5590000000000002</c:v>
                </c:pt>
                <c:pt idx="45">
                  <c:v>5.0940000000000003</c:v>
                </c:pt>
                <c:pt idx="46">
                  <c:v>2.5640000000000001</c:v>
                </c:pt>
                <c:pt idx="47">
                  <c:v>9.0690000000000008</c:v>
                </c:pt>
              </c:numCache>
            </c:numRef>
          </c:xVal>
          <c:yVal>
            <c:numRef>
              <c:f>'Fold change'!$AK$2:$AK$49</c:f>
              <c:numCache>
                <c:formatCode>General</c:formatCode>
                <c:ptCount val="48"/>
                <c:pt idx="0">
                  <c:v>9.64</c:v>
                </c:pt>
                <c:pt idx="1">
                  <c:v>18.571999999999999</c:v>
                </c:pt>
                <c:pt idx="2">
                  <c:v>9.1560000000000006</c:v>
                </c:pt>
                <c:pt idx="3">
                  <c:v>8.0709999999999997</c:v>
                </c:pt>
                <c:pt idx="4">
                  <c:v>19.324000000000002</c:v>
                </c:pt>
                <c:pt idx="5">
                  <c:v>8.6850000000000005</c:v>
                </c:pt>
                <c:pt idx="6">
                  <c:v>15.419</c:v>
                </c:pt>
                <c:pt idx="7">
                  <c:v>25.635000000000002</c:v>
                </c:pt>
                <c:pt idx="8">
                  <c:v>9.2260000000000009</c:v>
                </c:pt>
                <c:pt idx="9">
                  <c:v>12.686</c:v>
                </c:pt>
                <c:pt idx="10">
                  <c:v>12.172000000000001</c:v>
                </c:pt>
                <c:pt idx="11">
                  <c:v>5.5869999999999997</c:v>
                </c:pt>
                <c:pt idx="12">
                  <c:v>9.4640000000000004</c:v>
                </c:pt>
                <c:pt idx="13">
                  <c:v>4.2309999999999999</c:v>
                </c:pt>
                <c:pt idx="14">
                  <c:v>2.8340000000000001</c:v>
                </c:pt>
                <c:pt idx="15">
                  <c:v>5.4829999999999997</c:v>
                </c:pt>
                <c:pt idx="16">
                  <c:v>5.234</c:v>
                </c:pt>
                <c:pt idx="17">
                  <c:v>1.6879999999999999</c:v>
                </c:pt>
                <c:pt idx="18">
                  <c:v>1.0900000000000001</c:v>
                </c:pt>
                <c:pt idx="19">
                  <c:v>1.8480000000000001</c:v>
                </c:pt>
                <c:pt idx="20">
                  <c:v>3.1</c:v>
                </c:pt>
                <c:pt idx="21">
                  <c:v>4.7720000000000002</c:v>
                </c:pt>
                <c:pt idx="22">
                  <c:v>4.9539999999999997</c:v>
                </c:pt>
                <c:pt idx="23">
                  <c:v>8.0069999999999997</c:v>
                </c:pt>
                <c:pt idx="24">
                  <c:v>7.4029999999999996</c:v>
                </c:pt>
                <c:pt idx="25">
                  <c:v>25.547000000000001</c:v>
                </c:pt>
                <c:pt idx="26">
                  <c:v>8.3719999999999999</c:v>
                </c:pt>
                <c:pt idx="27">
                  <c:v>10.02</c:v>
                </c:pt>
                <c:pt idx="28">
                  <c:v>24.405000000000001</c:v>
                </c:pt>
                <c:pt idx="29">
                  <c:v>13.888</c:v>
                </c:pt>
                <c:pt idx="30">
                  <c:v>16.398</c:v>
                </c:pt>
                <c:pt idx="31">
                  <c:v>13.451000000000001</c:v>
                </c:pt>
                <c:pt idx="32">
                  <c:v>8.859</c:v>
                </c:pt>
                <c:pt idx="33">
                  <c:v>10.138</c:v>
                </c:pt>
                <c:pt idx="34">
                  <c:v>18.248000000000001</c:v>
                </c:pt>
                <c:pt idx="35">
                  <c:v>16.89</c:v>
                </c:pt>
                <c:pt idx="36">
                  <c:v>19.498999999999999</c:v>
                </c:pt>
                <c:pt idx="37">
                  <c:v>19.515999999999998</c:v>
                </c:pt>
                <c:pt idx="38">
                  <c:v>18.367000000000001</c:v>
                </c:pt>
                <c:pt idx="39">
                  <c:v>5.03</c:v>
                </c:pt>
                <c:pt idx="40">
                  <c:v>2.4630000000000001</c:v>
                </c:pt>
                <c:pt idx="41">
                  <c:v>4.0679999999999996</c:v>
                </c:pt>
                <c:pt idx="42">
                  <c:v>7.6820000000000004</c:v>
                </c:pt>
                <c:pt idx="43">
                  <c:v>13.103999999999999</c:v>
                </c:pt>
                <c:pt idx="44">
                  <c:v>17.72</c:v>
                </c:pt>
                <c:pt idx="45">
                  <c:v>12.289</c:v>
                </c:pt>
                <c:pt idx="46">
                  <c:v>8.2959999999999994</c:v>
                </c:pt>
                <c:pt idx="47">
                  <c:v>12.112</c:v>
                </c:pt>
              </c:numCache>
            </c:numRef>
          </c:yVal>
          <c:smooth val="0"/>
          <c:extLst>
            <c:ext xmlns:c16="http://schemas.microsoft.com/office/drawing/2014/chart" uri="{C3380CC4-5D6E-409C-BE32-E72D297353CC}">
              <c16:uniqueId val="{00000000-81DA-414D-881E-E6BD22509342}"/>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5</c:f>
              <c:numCache>
                <c:formatCode>General</c:formatCode>
                <c:ptCount val="4"/>
                <c:pt idx="0">
                  <c:v>0.1</c:v>
                </c:pt>
                <c:pt idx="1">
                  <c:v>1</c:v>
                </c:pt>
                <c:pt idx="2" formatCode="#,##0">
                  <c:v>10</c:v>
                </c:pt>
                <c:pt idx="3" formatCode="#,##0">
                  <c:v>100</c:v>
                </c:pt>
              </c:numCache>
            </c:numRef>
          </c:xVal>
          <c:yVal>
            <c:numRef>
              <c:f>'Fold change'!$C$2:$C$5</c:f>
              <c:numCache>
                <c:formatCode>#,##0</c:formatCode>
                <c:ptCount val="4"/>
                <c:pt idx="0" formatCode="General">
                  <c:v>0.1</c:v>
                </c:pt>
                <c:pt idx="1">
                  <c:v>1</c:v>
                </c:pt>
                <c:pt idx="2">
                  <c:v>10</c:v>
                </c:pt>
                <c:pt idx="3">
                  <c:v>100</c:v>
                </c:pt>
              </c:numCache>
            </c:numRef>
          </c:yVal>
          <c:smooth val="0"/>
          <c:extLst>
            <c:ext xmlns:c16="http://schemas.microsoft.com/office/drawing/2014/chart" uri="{C3380CC4-5D6E-409C-BE32-E72D297353CC}">
              <c16:uniqueId val="{00000002-81DA-414D-881E-E6BD22509342}"/>
            </c:ext>
          </c:extLst>
        </c:ser>
        <c:dLbls>
          <c:showLegendKey val="0"/>
          <c:showVal val="0"/>
          <c:showCatName val="0"/>
          <c:showSerName val="0"/>
          <c:showPercent val="0"/>
          <c:showBubbleSize val="0"/>
        </c:dLbls>
        <c:axId val="132788608"/>
        <c:axId val="132790528"/>
      </c:scatterChart>
      <c:valAx>
        <c:axId val="132788608"/>
        <c:scaling>
          <c:logBase val="10"/>
          <c:orientation val="minMax"/>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790528"/>
        <c:crossesAt val="0.1"/>
        <c:crossBetween val="midCat"/>
      </c:valAx>
      <c:valAx>
        <c:axId val="132790528"/>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2788608"/>
        <c:crossesAt val="0.1"/>
        <c:crossBetween val="midCat"/>
      </c:valAx>
    </c:plotArea>
    <c:plotVisOnly val="1"/>
    <c:dispBlanksAs val="gap"/>
    <c:showDLblsOverMax val="0"/>
  </c:chart>
  <c:spPr>
    <a:ln>
      <a:noFill/>
    </a:ln>
  </c:sp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Serotype 14</a:t>
            </a:r>
          </a:p>
        </c:rich>
      </c:tx>
      <c:overlay val="0"/>
    </c:title>
    <c:autoTitleDeleted val="0"/>
    <c:plotArea>
      <c:layout/>
      <c:scatterChart>
        <c:scatterStyle val="lineMarker"/>
        <c:varyColors val="0"/>
        <c:ser>
          <c:idx val="0"/>
          <c:order val="0"/>
          <c:tx>
            <c:strRef>
              <c:f>'Fold change'!$AN$1</c:f>
              <c:strCache>
                <c:ptCount val="1"/>
                <c:pt idx="0">
                  <c:v>S14_1</c:v>
                </c:pt>
              </c:strCache>
            </c:strRef>
          </c:tx>
          <c:spPr>
            <a:ln w="28575">
              <a:noFill/>
            </a:ln>
          </c:spPr>
          <c:xVal>
            <c:numRef>
              <c:f>'Fold change'!$AN$2:$AN$49</c:f>
              <c:numCache>
                <c:formatCode>General</c:formatCode>
                <c:ptCount val="48"/>
                <c:pt idx="0">
                  <c:v>13.609</c:v>
                </c:pt>
                <c:pt idx="1">
                  <c:v>13.646000000000001</c:v>
                </c:pt>
                <c:pt idx="2">
                  <c:v>7.9279999999999999</c:v>
                </c:pt>
                <c:pt idx="3">
                  <c:v>10.464</c:v>
                </c:pt>
                <c:pt idx="4">
                  <c:v>14.971</c:v>
                </c:pt>
                <c:pt idx="5">
                  <c:v>10.135</c:v>
                </c:pt>
                <c:pt idx="6">
                  <c:v>16.596</c:v>
                </c:pt>
                <c:pt idx="7">
                  <c:v>16.126000000000001</c:v>
                </c:pt>
                <c:pt idx="8">
                  <c:v>34.779000000000003</c:v>
                </c:pt>
                <c:pt idx="9">
                  <c:v>21.957999999999998</c:v>
                </c:pt>
                <c:pt idx="10">
                  <c:v>12.973000000000001</c:v>
                </c:pt>
                <c:pt idx="11">
                  <c:v>9.4540000000000006</c:v>
                </c:pt>
                <c:pt idx="12">
                  <c:v>29.37</c:v>
                </c:pt>
                <c:pt idx="13">
                  <c:v>3.4089999999999998</c:v>
                </c:pt>
                <c:pt idx="14">
                  <c:v>58.655999999999999</c:v>
                </c:pt>
                <c:pt idx="15">
                  <c:v>24.835000000000001</c:v>
                </c:pt>
                <c:pt idx="16">
                  <c:v>5.7789999999999999</c:v>
                </c:pt>
                <c:pt idx="17">
                  <c:v>15.593999999999999</c:v>
                </c:pt>
                <c:pt idx="18">
                  <c:v>19.635999999999999</c:v>
                </c:pt>
                <c:pt idx="19">
                  <c:v>46.679000000000002</c:v>
                </c:pt>
                <c:pt idx="20">
                  <c:v>3.9980000000000002</c:v>
                </c:pt>
                <c:pt idx="21">
                  <c:v>46.783000000000001</c:v>
                </c:pt>
                <c:pt idx="22">
                  <c:v>10.587999999999999</c:v>
                </c:pt>
                <c:pt idx="23">
                  <c:v>20.721</c:v>
                </c:pt>
                <c:pt idx="24">
                  <c:v>12.141999999999999</c:v>
                </c:pt>
                <c:pt idx="25">
                  <c:v>23.638000000000002</c:v>
                </c:pt>
                <c:pt idx="26">
                  <c:v>16.349</c:v>
                </c:pt>
                <c:pt idx="27">
                  <c:v>6.1909999999999998</c:v>
                </c:pt>
                <c:pt idx="28">
                  <c:v>20.555</c:v>
                </c:pt>
                <c:pt idx="29">
                  <c:v>3.242</c:v>
                </c:pt>
                <c:pt idx="30">
                  <c:v>18.672999999999998</c:v>
                </c:pt>
                <c:pt idx="31">
                  <c:v>17.518999999999998</c:v>
                </c:pt>
                <c:pt idx="32">
                  <c:v>18.224</c:v>
                </c:pt>
                <c:pt idx="33">
                  <c:v>17.695</c:v>
                </c:pt>
                <c:pt idx="34">
                  <c:v>12.16</c:v>
                </c:pt>
                <c:pt idx="35">
                  <c:v>23.1</c:v>
                </c:pt>
                <c:pt idx="36">
                  <c:v>58.585999999999999</c:v>
                </c:pt>
                <c:pt idx="37">
                  <c:v>61.954999999999998</c:v>
                </c:pt>
                <c:pt idx="38">
                  <c:v>20.939</c:v>
                </c:pt>
                <c:pt idx="39">
                  <c:v>9.2729999999999997</c:v>
                </c:pt>
                <c:pt idx="40">
                  <c:v>0.70099999999999996</c:v>
                </c:pt>
                <c:pt idx="41">
                  <c:v>21.550999999999998</c:v>
                </c:pt>
                <c:pt idx="42">
                  <c:v>48.341999999999999</c:v>
                </c:pt>
                <c:pt idx="43">
                  <c:v>12.324</c:v>
                </c:pt>
                <c:pt idx="44">
                  <c:v>25.096</c:v>
                </c:pt>
                <c:pt idx="45">
                  <c:v>13.041</c:v>
                </c:pt>
                <c:pt idx="46">
                  <c:v>28.622</c:v>
                </c:pt>
                <c:pt idx="47">
                  <c:v>12.244</c:v>
                </c:pt>
              </c:numCache>
            </c:numRef>
          </c:xVal>
          <c:yVal>
            <c:numRef>
              <c:f>'Fold change'!$AO$2:$AO$49</c:f>
              <c:numCache>
                <c:formatCode>General</c:formatCode>
                <c:ptCount val="48"/>
                <c:pt idx="0">
                  <c:v>60.947000000000003</c:v>
                </c:pt>
                <c:pt idx="1">
                  <c:v>24.745999999999999</c:v>
                </c:pt>
                <c:pt idx="2">
                  <c:v>23.771000000000001</c:v>
                </c:pt>
                <c:pt idx="3">
                  <c:v>39.155000000000001</c:v>
                </c:pt>
                <c:pt idx="4">
                  <c:v>23.251000000000001</c:v>
                </c:pt>
                <c:pt idx="5">
                  <c:v>16.271999999999998</c:v>
                </c:pt>
                <c:pt idx="6">
                  <c:v>30.52</c:v>
                </c:pt>
                <c:pt idx="7">
                  <c:v>68.781999999999996</c:v>
                </c:pt>
                <c:pt idx="8">
                  <c:v>42.061</c:v>
                </c:pt>
                <c:pt idx="9">
                  <c:v>26.41</c:v>
                </c:pt>
                <c:pt idx="10">
                  <c:v>27.446000000000002</c:v>
                </c:pt>
                <c:pt idx="11">
                  <c:v>10.939</c:v>
                </c:pt>
                <c:pt idx="12">
                  <c:v>151.49799999999999</c:v>
                </c:pt>
                <c:pt idx="13">
                  <c:v>25.161999999999999</c:v>
                </c:pt>
                <c:pt idx="14">
                  <c:v>66.584000000000003</c:v>
                </c:pt>
                <c:pt idx="15">
                  <c:v>24.678999999999998</c:v>
                </c:pt>
                <c:pt idx="16">
                  <c:v>13.201000000000001</c:v>
                </c:pt>
                <c:pt idx="17">
                  <c:v>26.879000000000001</c:v>
                </c:pt>
                <c:pt idx="18">
                  <c:v>26.917000000000002</c:v>
                </c:pt>
                <c:pt idx="19">
                  <c:v>47.143000000000001</c:v>
                </c:pt>
                <c:pt idx="20">
                  <c:v>6.4989999999999997</c:v>
                </c:pt>
                <c:pt idx="21">
                  <c:v>46.082999999999998</c:v>
                </c:pt>
                <c:pt idx="22">
                  <c:v>84.863</c:v>
                </c:pt>
                <c:pt idx="23">
                  <c:v>26.242999999999999</c:v>
                </c:pt>
                <c:pt idx="24">
                  <c:v>27.538</c:v>
                </c:pt>
                <c:pt idx="25">
                  <c:v>25.071999999999999</c:v>
                </c:pt>
                <c:pt idx="26">
                  <c:v>21.600999999999999</c:v>
                </c:pt>
                <c:pt idx="27">
                  <c:v>9.5350000000000001</c:v>
                </c:pt>
                <c:pt idx="28">
                  <c:v>67.039000000000001</c:v>
                </c:pt>
                <c:pt idx="29">
                  <c:v>17.308</c:v>
                </c:pt>
                <c:pt idx="30">
                  <c:v>34.771000000000001</c:v>
                </c:pt>
                <c:pt idx="31">
                  <c:v>15.659000000000001</c:v>
                </c:pt>
                <c:pt idx="32">
                  <c:v>18.216999999999999</c:v>
                </c:pt>
                <c:pt idx="33">
                  <c:v>30.263999999999999</c:v>
                </c:pt>
                <c:pt idx="34">
                  <c:v>39.603000000000002</c:v>
                </c:pt>
                <c:pt idx="35">
                  <c:v>23.263999999999999</c:v>
                </c:pt>
                <c:pt idx="36">
                  <c:v>108.28700000000001</c:v>
                </c:pt>
                <c:pt idx="37">
                  <c:v>56.787999999999997</c:v>
                </c:pt>
                <c:pt idx="38">
                  <c:v>26.817</c:v>
                </c:pt>
                <c:pt idx="39">
                  <c:v>9.8960000000000008</c:v>
                </c:pt>
                <c:pt idx="40">
                  <c:v>1.482</c:v>
                </c:pt>
                <c:pt idx="41">
                  <c:v>51.459000000000003</c:v>
                </c:pt>
                <c:pt idx="42">
                  <c:v>39.585999999999999</c:v>
                </c:pt>
                <c:pt idx="43">
                  <c:v>17.327000000000002</c:v>
                </c:pt>
                <c:pt idx="44">
                  <c:v>32.234999999999999</c:v>
                </c:pt>
                <c:pt idx="45">
                  <c:v>42.545999999999999</c:v>
                </c:pt>
                <c:pt idx="46">
                  <c:v>31.027999999999999</c:v>
                </c:pt>
                <c:pt idx="47">
                  <c:v>42.024999999999999</c:v>
                </c:pt>
              </c:numCache>
            </c:numRef>
          </c:yVal>
          <c:smooth val="0"/>
          <c:extLst>
            <c:ext xmlns:c16="http://schemas.microsoft.com/office/drawing/2014/chart" uri="{C3380CC4-5D6E-409C-BE32-E72D297353CC}">
              <c16:uniqueId val="{00000000-5D10-4CEC-98EC-5AF23D62A82B}"/>
            </c:ext>
          </c:extLst>
        </c:ser>
        <c:ser>
          <c:idx val="1"/>
          <c:order val="1"/>
          <c:tx>
            <c:strRef>
              <c:f>'Fold change'!$B$1</c:f>
              <c:strCache>
                <c:ptCount val="1"/>
                <c:pt idx="0">
                  <c:v>Ref line</c:v>
                </c:pt>
              </c:strCache>
            </c:strRef>
          </c:tx>
          <c:spPr>
            <a:ln w="28575">
              <a:noFill/>
            </a:ln>
          </c:spPr>
          <c:marker>
            <c:symbol val="none"/>
          </c:marker>
          <c:trendline>
            <c:trendlineType val="linear"/>
            <c:dispRSqr val="0"/>
            <c:dispEq val="0"/>
          </c:trendline>
          <c:xVal>
            <c:numRef>
              <c:f>'Fold change'!$B$2:$B$6</c:f>
              <c:numCache>
                <c:formatCode>General</c:formatCode>
                <c:ptCount val="5"/>
                <c:pt idx="0">
                  <c:v>0.1</c:v>
                </c:pt>
                <c:pt idx="1">
                  <c:v>1</c:v>
                </c:pt>
                <c:pt idx="2" formatCode="#,##0">
                  <c:v>10</c:v>
                </c:pt>
                <c:pt idx="3" formatCode="#,##0">
                  <c:v>100</c:v>
                </c:pt>
                <c:pt idx="4">
                  <c:v>1000</c:v>
                </c:pt>
              </c:numCache>
            </c:numRef>
          </c:xVal>
          <c:yVal>
            <c:numRef>
              <c:f>'Fold change'!$C$2:$C$6</c:f>
              <c:numCache>
                <c:formatCode>#,##0</c:formatCode>
                <c:ptCount val="5"/>
                <c:pt idx="0" formatCode="General">
                  <c:v>0.1</c:v>
                </c:pt>
                <c:pt idx="1">
                  <c:v>1</c:v>
                </c:pt>
                <c:pt idx="2">
                  <c:v>10</c:v>
                </c:pt>
                <c:pt idx="3">
                  <c:v>100</c:v>
                </c:pt>
                <c:pt idx="4" formatCode="General">
                  <c:v>1000</c:v>
                </c:pt>
              </c:numCache>
            </c:numRef>
          </c:yVal>
          <c:smooth val="0"/>
          <c:extLst>
            <c:ext xmlns:c16="http://schemas.microsoft.com/office/drawing/2014/chart" uri="{C3380CC4-5D6E-409C-BE32-E72D297353CC}">
              <c16:uniqueId val="{00000002-5D10-4CEC-98EC-5AF23D62A82B}"/>
            </c:ext>
          </c:extLst>
        </c:ser>
        <c:dLbls>
          <c:showLegendKey val="0"/>
          <c:showVal val="0"/>
          <c:showCatName val="0"/>
          <c:showSerName val="0"/>
          <c:showPercent val="0"/>
          <c:showBubbleSize val="0"/>
        </c:dLbls>
        <c:axId val="132817664"/>
        <c:axId val="132819584"/>
      </c:scatterChart>
      <c:valAx>
        <c:axId val="132817664"/>
        <c:scaling>
          <c:logBase val="10"/>
          <c:orientation val="minMax"/>
          <c:max val="1000"/>
          <c:min val="0.1"/>
        </c:scaling>
        <c:delete val="0"/>
        <c:axPos val="b"/>
        <c:title>
          <c:tx>
            <c:rich>
              <a:bodyPr/>
              <a:lstStyle/>
              <a:p>
                <a:pPr>
                  <a:defRPr/>
                </a:pPr>
                <a:r>
                  <a:rPr lang="en-US" dirty="0"/>
                  <a:t>Pre-PCV</a:t>
                </a:r>
                <a:r>
                  <a:rPr lang="en-US" baseline="0" dirty="0"/>
                  <a:t> </a:t>
                </a:r>
                <a:r>
                  <a:rPr lang="en-US" dirty="0"/>
                  <a:t>IgG titers</a:t>
                </a:r>
                <a:r>
                  <a:rPr lang="en-US" baseline="0" dirty="0"/>
                  <a:t> </a:t>
                </a:r>
                <a:r>
                  <a:rPr lang="en-US" dirty="0"/>
                  <a:t>(</a:t>
                </a:r>
                <a:r>
                  <a:rPr lang="en-US" sz="1000" b="1" i="0" u="none" strike="noStrike" baseline="0" dirty="0">
                    <a:effectLst/>
                  </a:rPr>
                  <a:t>µg/mL)</a:t>
                </a:r>
                <a:endParaRPr lang="en-US" dirty="0"/>
              </a:p>
            </c:rich>
          </c:tx>
          <c:overlay val="0"/>
        </c:title>
        <c:numFmt formatCode="General" sourceLinked="1"/>
        <c:majorTickMark val="out"/>
        <c:minorTickMark val="out"/>
        <c:tickLblPos val="nextTo"/>
        <c:crossAx val="132819584"/>
        <c:crossesAt val="0.1"/>
        <c:crossBetween val="midCat"/>
      </c:valAx>
      <c:valAx>
        <c:axId val="132819584"/>
        <c:scaling>
          <c:logBase val="10"/>
          <c:orientation val="minMax"/>
        </c:scaling>
        <c:delete val="0"/>
        <c:axPos val="l"/>
        <c:majorGridlines/>
        <c:title>
          <c:tx>
            <c:rich>
              <a:bodyPr rot="-5400000" vert="horz"/>
              <a:lstStyle/>
              <a:p>
                <a:pPr>
                  <a:defRPr sz="1100"/>
                </a:pPr>
                <a:r>
                  <a:rPr lang="en-AU" sz="1100" dirty="0"/>
                  <a:t>Post-PCV  IgG</a:t>
                </a:r>
                <a:r>
                  <a:rPr lang="en-AU" sz="1100" baseline="0" dirty="0"/>
                  <a:t> (</a:t>
                </a:r>
                <a:r>
                  <a:rPr lang="en-US" sz="1100" b="1" i="0" u="none" strike="noStrike" baseline="0" dirty="0">
                    <a:effectLst/>
                  </a:rPr>
                  <a:t>µg/mL)</a:t>
                </a:r>
                <a:endParaRPr lang="en-AU" sz="1100" dirty="0"/>
              </a:p>
            </c:rich>
          </c:tx>
          <c:overlay val="0"/>
        </c:title>
        <c:numFmt formatCode="General" sourceLinked="1"/>
        <c:majorTickMark val="out"/>
        <c:minorTickMark val="out"/>
        <c:tickLblPos val="nextTo"/>
        <c:crossAx val="132817664"/>
        <c:crossesAt val="0.1"/>
        <c:crossBetween val="midCat"/>
      </c:valAx>
    </c:plotArea>
    <c:plotVisOnly val="1"/>
    <c:dispBlanksAs val="gap"/>
    <c:showDLblsOverMax val="0"/>
  </c:chart>
  <c:spPr>
    <a:ln>
      <a:no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0D305A7-4AD0-476F-88C7-F6B45DD3F7E6}" type="datetimeFigureOut">
              <a:rPr lang="en-AU" smtClean="0"/>
              <a:t>15/10/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23052158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305A7-4AD0-476F-88C7-F6B45DD3F7E6}" type="datetimeFigureOut">
              <a:rPr lang="en-AU" smtClean="0"/>
              <a:t>15/10/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23075875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305A7-4AD0-476F-88C7-F6B45DD3F7E6}" type="datetimeFigureOut">
              <a:rPr lang="en-AU" smtClean="0"/>
              <a:t>15/10/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518013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305A7-4AD0-476F-88C7-F6B45DD3F7E6}" type="datetimeFigureOut">
              <a:rPr lang="en-AU" smtClean="0"/>
              <a:t>15/10/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8806838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D305A7-4AD0-476F-88C7-F6B45DD3F7E6}" type="datetimeFigureOut">
              <a:rPr lang="en-AU" smtClean="0"/>
              <a:t>15/10/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16153816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0D305A7-4AD0-476F-88C7-F6B45DD3F7E6}" type="datetimeFigureOut">
              <a:rPr lang="en-AU" smtClean="0"/>
              <a:t>15/10/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6700247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0D305A7-4AD0-476F-88C7-F6B45DD3F7E6}" type="datetimeFigureOut">
              <a:rPr lang="en-AU" smtClean="0"/>
              <a:t>15/10/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1265272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0D305A7-4AD0-476F-88C7-F6B45DD3F7E6}" type="datetimeFigureOut">
              <a:rPr lang="en-AU" smtClean="0"/>
              <a:t>15/10/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18862220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D305A7-4AD0-476F-88C7-F6B45DD3F7E6}" type="datetimeFigureOut">
              <a:rPr lang="en-AU" smtClean="0"/>
              <a:t>15/10/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4007461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0D305A7-4AD0-476F-88C7-F6B45DD3F7E6}" type="datetimeFigureOut">
              <a:rPr lang="en-AU" smtClean="0"/>
              <a:t>15/10/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34333303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0D305A7-4AD0-476F-88C7-F6B45DD3F7E6}" type="datetimeFigureOut">
              <a:rPr lang="en-AU" smtClean="0"/>
              <a:t>15/10/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AA88F5F-30BF-4060-B353-B79A13C3F837}" type="slidenum">
              <a:rPr lang="en-AU" smtClean="0"/>
              <a:t>‹#›</a:t>
            </a:fld>
            <a:endParaRPr lang="en-AU"/>
          </a:p>
        </p:txBody>
      </p:sp>
    </p:spTree>
    <p:extLst>
      <p:ext uri="{BB962C8B-B14F-4D97-AF65-F5344CB8AC3E}">
        <p14:creationId xmlns:p14="http://schemas.microsoft.com/office/powerpoint/2010/main" val="3597516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0D305A7-4AD0-476F-88C7-F6B45DD3F7E6}" type="datetimeFigureOut">
              <a:rPr lang="en-AU" smtClean="0"/>
              <a:t>15/10/2020</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AA88F5F-30BF-4060-B353-B79A13C3F837}" type="slidenum">
              <a:rPr lang="en-AU" smtClean="0"/>
              <a:t>‹#›</a:t>
            </a:fld>
            <a:endParaRPr lang="en-AU"/>
          </a:p>
        </p:txBody>
      </p:sp>
    </p:spTree>
    <p:extLst>
      <p:ext uri="{BB962C8B-B14F-4D97-AF65-F5344CB8AC3E}">
        <p14:creationId xmlns:p14="http://schemas.microsoft.com/office/powerpoint/2010/main" val="136772894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8.xml"/><Relationship Id="rId7" Type="http://schemas.openxmlformats.org/officeDocument/2006/relationships/chart" Target="../charts/chart12.xml"/><Relationship Id="rId2" Type="http://schemas.openxmlformats.org/officeDocument/2006/relationships/chart" Target="../charts/chart7.xml"/><Relationship Id="rId1" Type="http://schemas.openxmlformats.org/officeDocument/2006/relationships/slideLayout" Target="../slideLayouts/slideLayout2.xml"/><Relationship Id="rId6" Type="http://schemas.openxmlformats.org/officeDocument/2006/relationships/chart" Target="../charts/chart11.xml"/><Relationship Id="rId5" Type="http://schemas.openxmlformats.org/officeDocument/2006/relationships/chart" Target="../charts/chart10.xml"/><Relationship Id="rId4" Type="http://schemas.openxmlformats.org/officeDocument/2006/relationships/chart" Target="../charts/chart9.xml"/></Relationships>
</file>

<file path=ppt/slides/_rels/slide3.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938341484"/>
              </p:ext>
            </p:extLst>
          </p:nvPr>
        </p:nvGraphicFramePr>
        <p:xfrm>
          <a:off x="180975" y="1278324"/>
          <a:ext cx="3010437" cy="283197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00000000-0008-0000-0100-000004000000}"/>
              </a:ext>
            </a:extLst>
          </p:cNvPr>
          <p:cNvGraphicFramePr>
            <a:graphicFrameLocks/>
          </p:cNvGraphicFramePr>
          <p:nvPr>
            <p:extLst>
              <p:ext uri="{D42A27DB-BD31-4B8C-83A1-F6EECF244321}">
                <p14:modId xmlns:p14="http://schemas.microsoft.com/office/powerpoint/2010/main" val="1773720343"/>
              </p:ext>
            </p:extLst>
          </p:nvPr>
        </p:nvGraphicFramePr>
        <p:xfrm>
          <a:off x="3429000" y="1278324"/>
          <a:ext cx="3010437" cy="283197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00000000-0008-0000-0100-000005000000}"/>
              </a:ext>
            </a:extLst>
          </p:cNvPr>
          <p:cNvGraphicFramePr>
            <a:graphicFrameLocks/>
          </p:cNvGraphicFramePr>
          <p:nvPr>
            <p:extLst>
              <p:ext uri="{D42A27DB-BD31-4B8C-83A1-F6EECF244321}">
                <p14:modId xmlns:p14="http://schemas.microsoft.com/office/powerpoint/2010/main" val="2425681361"/>
              </p:ext>
            </p:extLst>
          </p:nvPr>
        </p:nvGraphicFramePr>
        <p:xfrm>
          <a:off x="180976" y="4110302"/>
          <a:ext cx="3010437" cy="283197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00000000-0008-0000-0100-000006000000}"/>
              </a:ext>
            </a:extLst>
          </p:cNvPr>
          <p:cNvGraphicFramePr>
            <a:graphicFrameLocks/>
          </p:cNvGraphicFramePr>
          <p:nvPr>
            <p:extLst>
              <p:ext uri="{D42A27DB-BD31-4B8C-83A1-F6EECF244321}">
                <p14:modId xmlns:p14="http://schemas.microsoft.com/office/powerpoint/2010/main" val="3659686591"/>
              </p:ext>
            </p:extLst>
          </p:nvPr>
        </p:nvGraphicFramePr>
        <p:xfrm>
          <a:off x="3429000" y="4110302"/>
          <a:ext cx="3010437" cy="283197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8" name="Chart 7">
            <a:extLst>
              <a:ext uri="{FF2B5EF4-FFF2-40B4-BE49-F238E27FC236}">
                <a16:creationId xmlns:a16="http://schemas.microsoft.com/office/drawing/2014/main" id="{00000000-0008-0000-0100-000007000000}"/>
              </a:ext>
            </a:extLst>
          </p:cNvPr>
          <p:cNvGraphicFramePr>
            <a:graphicFrameLocks/>
          </p:cNvGraphicFramePr>
          <p:nvPr>
            <p:extLst>
              <p:ext uri="{D42A27DB-BD31-4B8C-83A1-F6EECF244321}">
                <p14:modId xmlns:p14="http://schemas.microsoft.com/office/powerpoint/2010/main" val="557082574"/>
              </p:ext>
            </p:extLst>
          </p:nvPr>
        </p:nvGraphicFramePr>
        <p:xfrm>
          <a:off x="180975" y="6942282"/>
          <a:ext cx="3010437" cy="2831978"/>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a:extLst>
              <a:ext uri="{FF2B5EF4-FFF2-40B4-BE49-F238E27FC236}">
                <a16:creationId xmlns:a16="http://schemas.microsoft.com/office/drawing/2014/main" id="{00000000-0008-0000-0100-000008000000}"/>
              </a:ext>
            </a:extLst>
          </p:cNvPr>
          <p:cNvGraphicFramePr>
            <a:graphicFrameLocks/>
          </p:cNvGraphicFramePr>
          <p:nvPr>
            <p:extLst>
              <p:ext uri="{D42A27DB-BD31-4B8C-83A1-F6EECF244321}">
                <p14:modId xmlns:p14="http://schemas.microsoft.com/office/powerpoint/2010/main" val="566601345"/>
              </p:ext>
            </p:extLst>
          </p:nvPr>
        </p:nvGraphicFramePr>
        <p:xfrm>
          <a:off x="3609975" y="6942280"/>
          <a:ext cx="3010437" cy="2831978"/>
        </p:xfrm>
        <a:graphic>
          <a:graphicData uri="http://schemas.openxmlformats.org/drawingml/2006/chart">
            <c:chart xmlns:c="http://schemas.openxmlformats.org/drawingml/2006/chart" xmlns:r="http://schemas.openxmlformats.org/officeDocument/2006/relationships" r:id="rId7"/>
          </a:graphicData>
        </a:graphic>
      </p:graphicFrame>
      <p:sp>
        <p:nvSpPr>
          <p:cNvPr id="2" name="TextBox 1">
            <a:extLst>
              <a:ext uri="{FF2B5EF4-FFF2-40B4-BE49-F238E27FC236}">
                <a16:creationId xmlns:a16="http://schemas.microsoft.com/office/drawing/2014/main" id="{7C3169FA-375F-47C6-B901-CC8E27E757D0}"/>
              </a:ext>
            </a:extLst>
          </p:cNvPr>
          <p:cNvSpPr txBox="1"/>
          <p:nvPr/>
        </p:nvSpPr>
        <p:spPr>
          <a:xfrm>
            <a:off x="499610" y="447325"/>
            <a:ext cx="5858777" cy="830997"/>
          </a:xfrm>
          <a:prstGeom prst="rect">
            <a:avLst/>
          </a:prstGeom>
          <a:noFill/>
        </p:spPr>
        <p:txBody>
          <a:bodyPr wrap="square" rtlCol="0">
            <a:spAutoFit/>
          </a:bodyPr>
          <a:lstStyle/>
          <a:p>
            <a:pPr algn="just"/>
            <a:r>
              <a:rPr lang="en-US" sz="1200" b="1" dirty="0"/>
              <a:t>Supplementary Figure </a:t>
            </a:r>
            <a:r>
              <a:rPr lang="en-US" sz="1200" dirty="0"/>
              <a:t>1. Serotype specific IgG responses before compared to after vaccination with one dose of  PCV13 in 48 healthy women of childbearing age in Papua New Guinea. Serotypes included in PCV13 are depicted in blue; non-vaccine serotype 2 in red.</a:t>
            </a:r>
            <a:endParaRPr lang="en-AU" sz="1200" dirty="0"/>
          </a:p>
        </p:txBody>
      </p:sp>
    </p:spTree>
    <p:extLst>
      <p:ext uri="{BB962C8B-B14F-4D97-AF65-F5344CB8AC3E}">
        <p14:creationId xmlns:p14="http://schemas.microsoft.com/office/powerpoint/2010/main" val="3039300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0000000-0008-0000-0100-000009000000}"/>
              </a:ext>
            </a:extLst>
          </p:cNvPr>
          <p:cNvGraphicFramePr>
            <a:graphicFrameLocks/>
          </p:cNvGraphicFramePr>
          <p:nvPr>
            <p:extLst>
              <p:ext uri="{D42A27DB-BD31-4B8C-83A1-F6EECF244321}">
                <p14:modId xmlns:p14="http://schemas.microsoft.com/office/powerpoint/2010/main" val="3957289987"/>
              </p:ext>
            </p:extLst>
          </p:nvPr>
        </p:nvGraphicFramePr>
        <p:xfrm>
          <a:off x="244700" y="285348"/>
          <a:ext cx="3005204" cy="272894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00000000-0008-0000-0100-00000A000000}"/>
              </a:ext>
            </a:extLst>
          </p:cNvPr>
          <p:cNvGraphicFramePr>
            <a:graphicFrameLocks/>
          </p:cNvGraphicFramePr>
          <p:nvPr>
            <p:extLst>
              <p:ext uri="{D42A27DB-BD31-4B8C-83A1-F6EECF244321}">
                <p14:modId xmlns:p14="http://schemas.microsoft.com/office/powerpoint/2010/main" val="2617251210"/>
              </p:ext>
            </p:extLst>
          </p:nvPr>
        </p:nvGraphicFramePr>
        <p:xfrm>
          <a:off x="3172699" y="285348"/>
          <a:ext cx="3005204" cy="272894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00000000-0008-0000-0100-00000B000000}"/>
              </a:ext>
            </a:extLst>
          </p:cNvPr>
          <p:cNvGraphicFramePr>
            <a:graphicFrameLocks/>
          </p:cNvGraphicFramePr>
          <p:nvPr>
            <p:extLst>
              <p:ext uri="{D42A27DB-BD31-4B8C-83A1-F6EECF244321}">
                <p14:modId xmlns:p14="http://schemas.microsoft.com/office/powerpoint/2010/main" val="2542337368"/>
              </p:ext>
            </p:extLst>
          </p:nvPr>
        </p:nvGraphicFramePr>
        <p:xfrm>
          <a:off x="244700" y="3014296"/>
          <a:ext cx="3005204" cy="272894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00000000-0008-0000-0100-00000C000000}"/>
              </a:ext>
            </a:extLst>
          </p:cNvPr>
          <p:cNvGraphicFramePr>
            <a:graphicFrameLocks/>
          </p:cNvGraphicFramePr>
          <p:nvPr>
            <p:extLst>
              <p:ext uri="{D42A27DB-BD31-4B8C-83A1-F6EECF244321}">
                <p14:modId xmlns:p14="http://schemas.microsoft.com/office/powerpoint/2010/main" val="2422695637"/>
              </p:ext>
            </p:extLst>
          </p:nvPr>
        </p:nvGraphicFramePr>
        <p:xfrm>
          <a:off x="3249904" y="3028550"/>
          <a:ext cx="3005204" cy="272894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8" name="Chart 7">
            <a:extLst>
              <a:ext uri="{FF2B5EF4-FFF2-40B4-BE49-F238E27FC236}">
                <a16:creationId xmlns:a16="http://schemas.microsoft.com/office/drawing/2014/main" id="{00000000-0008-0000-0100-00000D000000}"/>
              </a:ext>
            </a:extLst>
          </p:cNvPr>
          <p:cNvGraphicFramePr>
            <a:graphicFrameLocks/>
          </p:cNvGraphicFramePr>
          <p:nvPr>
            <p:extLst>
              <p:ext uri="{D42A27DB-BD31-4B8C-83A1-F6EECF244321}">
                <p14:modId xmlns:p14="http://schemas.microsoft.com/office/powerpoint/2010/main" val="1909795373"/>
              </p:ext>
            </p:extLst>
          </p:nvPr>
        </p:nvGraphicFramePr>
        <p:xfrm>
          <a:off x="244700" y="5779129"/>
          <a:ext cx="3005204" cy="2728948"/>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a:extLst>
              <a:ext uri="{FF2B5EF4-FFF2-40B4-BE49-F238E27FC236}">
                <a16:creationId xmlns:a16="http://schemas.microsoft.com/office/drawing/2014/main" id="{00000000-0008-0000-0100-00000E000000}"/>
              </a:ext>
            </a:extLst>
          </p:cNvPr>
          <p:cNvGraphicFramePr>
            <a:graphicFrameLocks/>
          </p:cNvGraphicFramePr>
          <p:nvPr>
            <p:extLst>
              <p:ext uri="{D42A27DB-BD31-4B8C-83A1-F6EECF244321}">
                <p14:modId xmlns:p14="http://schemas.microsoft.com/office/powerpoint/2010/main" val="4203127128"/>
              </p:ext>
            </p:extLst>
          </p:nvPr>
        </p:nvGraphicFramePr>
        <p:xfrm>
          <a:off x="3327109" y="5743244"/>
          <a:ext cx="3005204" cy="2728948"/>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13753592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0000000-0008-0000-0100-00000F000000}"/>
              </a:ext>
            </a:extLst>
          </p:cNvPr>
          <p:cNvGraphicFramePr>
            <a:graphicFrameLocks/>
          </p:cNvGraphicFramePr>
          <p:nvPr>
            <p:extLst>
              <p:ext uri="{D42A27DB-BD31-4B8C-83A1-F6EECF244321}">
                <p14:modId xmlns:p14="http://schemas.microsoft.com/office/powerpoint/2010/main" val="3079891526"/>
              </p:ext>
            </p:extLst>
          </p:nvPr>
        </p:nvGraphicFramePr>
        <p:xfrm>
          <a:off x="310367" y="721218"/>
          <a:ext cx="2937658" cy="237048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698113241"/>
              </p:ext>
            </p:extLst>
          </p:nvPr>
        </p:nvGraphicFramePr>
        <p:xfrm>
          <a:off x="3609977" y="721218"/>
          <a:ext cx="2937658" cy="2370484"/>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28930606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TotalTime>
  <Words>283</Words>
  <Application>Microsoft Office PowerPoint</Application>
  <PresentationFormat>A4 Paper (210x297 mm)</PresentationFormat>
  <Paragraphs>43</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ita Van Den Biggelaar</dc:creator>
  <cp:lastModifiedBy>Anita van den Biggelaar</cp:lastModifiedBy>
  <cp:revision>4</cp:revision>
  <dcterms:created xsi:type="dcterms:W3CDTF">2019-10-24T05:12:47Z</dcterms:created>
  <dcterms:modified xsi:type="dcterms:W3CDTF">2020-10-15T03:02:47Z</dcterms:modified>
</cp:coreProperties>
</file>